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00"/>
    <a:srgbClr val="FFFF66"/>
    <a:srgbClr val="FFFF99"/>
    <a:srgbClr val="CC99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>
        <p:scale>
          <a:sx n="50" d="100"/>
          <a:sy n="50" d="100"/>
        </p:scale>
        <p:origin x="-2059" y="346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0632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900275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619479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1744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008714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1366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88223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25258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91594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18241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010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56FB7B-43BC-454F-9FB1-C2E4B1B8A7F4}" type="datetimeFigureOut">
              <a:rPr lang="en-US" smtClean="0"/>
              <a:t>2/2/201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070F47C-CFD3-4A80-9159-E6FEA91B5A9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0735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232356" y="1066482"/>
            <a:ext cx="4406444" cy="6934518"/>
            <a:chOff x="1232356" y="1066482"/>
            <a:chExt cx="4406444" cy="6934518"/>
          </a:xfrm>
        </p:grpSpPr>
        <p:grpSp>
          <p:nvGrpSpPr>
            <p:cNvPr id="451" name="Group 450"/>
            <p:cNvGrpSpPr/>
            <p:nvPr/>
          </p:nvGrpSpPr>
          <p:grpSpPr>
            <a:xfrm>
              <a:off x="1232356" y="1143000"/>
              <a:ext cx="4406444" cy="6858000"/>
              <a:chOff x="1232356" y="1143000"/>
              <a:chExt cx="4406444" cy="6858000"/>
            </a:xfrm>
          </p:grpSpPr>
          <p:grpSp>
            <p:nvGrpSpPr>
              <p:cNvPr id="443" name="Group 442"/>
              <p:cNvGrpSpPr/>
              <p:nvPr/>
            </p:nvGrpSpPr>
            <p:grpSpPr>
              <a:xfrm>
                <a:off x="1232356" y="1143000"/>
                <a:ext cx="2031017" cy="1613502"/>
                <a:chOff x="1232356" y="354013"/>
                <a:chExt cx="2031017" cy="1613502"/>
              </a:xfrm>
            </p:grpSpPr>
            <p:grpSp>
              <p:nvGrpSpPr>
                <p:cNvPr id="435" name="Group 434"/>
                <p:cNvGrpSpPr/>
                <p:nvPr/>
              </p:nvGrpSpPr>
              <p:grpSpPr>
                <a:xfrm>
                  <a:off x="1371600" y="354013"/>
                  <a:ext cx="1891773" cy="1613502"/>
                  <a:chOff x="1341966" y="354013"/>
                  <a:chExt cx="1891773" cy="1613502"/>
                </a:xfrm>
              </p:grpSpPr>
              <p:grpSp>
                <p:nvGrpSpPr>
                  <p:cNvPr id="426" name="Group 425"/>
                  <p:cNvGrpSpPr/>
                  <p:nvPr/>
                </p:nvGrpSpPr>
                <p:grpSpPr>
                  <a:xfrm>
                    <a:off x="1625601" y="354013"/>
                    <a:ext cx="1608138" cy="1241425"/>
                    <a:chOff x="1625601" y="354013"/>
                    <a:chExt cx="1608138" cy="1241425"/>
                  </a:xfrm>
                </p:grpSpPr>
                <p:sp>
                  <p:nvSpPr>
                    <p:cNvPr id="4" name="Rectangle 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625601" y="354013"/>
                      <a:ext cx="1608138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5" name="Rectangle 6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676401" y="1031875"/>
                      <a:ext cx="301625" cy="563563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6" name="Freeform 7"/>
                    <p:cNvSpPr>
                      <a:spLocks/>
                    </p:cNvSpPr>
                    <p:nvPr/>
                  </p:nvSpPr>
                  <p:spPr bwMode="auto">
                    <a:xfrm>
                      <a:off x="1676401" y="1031875"/>
                      <a:ext cx="301625" cy="563563"/>
                    </a:xfrm>
                    <a:custGeom>
                      <a:avLst/>
                      <a:gdLst>
                        <a:gd name="T0" fmla="*/ 0 w 570"/>
                        <a:gd name="T1" fmla="*/ 0 h 1066"/>
                        <a:gd name="T2" fmla="*/ 570 w 570"/>
                        <a:gd name="T3" fmla="*/ 0 h 1066"/>
                        <a:gd name="T4" fmla="*/ 570 w 570"/>
                        <a:gd name="T5" fmla="*/ 1066 h 1066"/>
                        <a:gd name="T6" fmla="*/ 0 w 570"/>
                        <a:gd name="T7" fmla="*/ 1066 h 106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</a:cxnLst>
                      <a:rect l="0" t="0" r="r" b="b"/>
                      <a:pathLst>
                        <a:path w="570" h="1066">
                          <a:moveTo>
                            <a:pt x="0" y="0"/>
                          </a:moveTo>
                          <a:lnTo>
                            <a:pt x="570" y="0"/>
                          </a:lnTo>
                          <a:lnTo>
                            <a:pt x="570" y="1066"/>
                          </a:lnTo>
                          <a:lnTo>
                            <a:pt x="0" y="1066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7" name="Line 8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1625601" y="1031875"/>
                      <a:ext cx="0" cy="563563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8" name="Rectangle 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078038" y="946150"/>
                      <a:ext cx="301625" cy="649288"/>
                    </a:xfrm>
                    <a:prstGeom prst="rect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  <a:ln w="9525">
                      <a:solidFill>
                        <a:schemeClr val="tx1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" name="Freeform 10"/>
                    <p:cNvSpPr>
                      <a:spLocks/>
                    </p:cNvSpPr>
                    <p:nvPr/>
                  </p:nvSpPr>
                  <p:spPr bwMode="auto">
                    <a:xfrm>
                      <a:off x="2078038" y="946150"/>
                      <a:ext cx="301625" cy="649288"/>
                    </a:xfrm>
                    <a:custGeom>
                      <a:avLst/>
                      <a:gdLst>
                        <a:gd name="T0" fmla="*/ 0 w 570"/>
                        <a:gd name="T1" fmla="*/ 0 h 1227"/>
                        <a:gd name="T2" fmla="*/ 570 w 570"/>
                        <a:gd name="T3" fmla="*/ 0 h 1227"/>
                        <a:gd name="T4" fmla="*/ 570 w 570"/>
                        <a:gd name="T5" fmla="*/ 1227 h 1227"/>
                        <a:gd name="T6" fmla="*/ 0 w 570"/>
                        <a:gd name="T7" fmla="*/ 1227 h 1227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</a:cxnLst>
                      <a:rect l="0" t="0" r="r" b="b"/>
                      <a:pathLst>
                        <a:path w="570" h="1227">
                          <a:moveTo>
                            <a:pt x="0" y="0"/>
                          </a:moveTo>
                          <a:lnTo>
                            <a:pt x="570" y="0"/>
                          </a:lnTo>
                          <a:lnTo>
                            <a:pt x="570" y="1227"/>
                          </a:lnTo>
                          <a:lnTo>
                            <a:pt x="0" y="1227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" name="Line 11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078038" y="946150"/>
                      <a:ext cx="0" cy="649288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" name="Freeform 18"/>
                    <p:cNvSpPr>
                      <a:spLocks/>
                    </p:cNvSpPr>
                    <p:nvPr/>
                  </p:nvSpPr>
                  <p:spPr bwMode="auto">
                    <a:xfrm flipV="1">
                      <a:off x="1827213" y="1014413"/>
                      <a:ext cx="0" cy="17463"/>
                    </a:xfrm>
                    <a:custGeom>
                      <a:avLst/>
                      <a:gdLst>
                        <a:gd name="T0" fmla="*/ 27 h 27"/>
                        <a:gd name="T1" fmla="*/ 0 h 27"/>
                        <a:gd name="T2" fmla="*/ 0 h 27"/>
                      </a:gdLst>
                      <a:ahLst/>
                      <a:cxnLst>
                        <a:cxn ang="0">
                          <a:pos x="0" y="T0"/>
                        </a:cxn>
                        <a:cxn ang="0">
                          <a:pos x="0" y="T1"/>
                        </a:cxn>
                        <a:cxn ang="0">
                          <a:pos x="0" y="T2"/>
                        </a:cxn>
                      </a:cxnLst>
                      <a:rect l="0" t="0" r="r" b="b"/>
                      <a:pathLst>
                        <a:path h="27">
                          <a:moveTo>
                            <a:pt x="0" y="27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8" name="Line 1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800226" y="1014413"/>
                      <a:ext cx="53975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9" name="Freeform 20"/>
                    <p:cNvSpPr>
                      <a:spLocks/>
                    </p:cNvSpPr>
                    <p:nvPr/>
                  </p:nvSpPr>
                  <p:spPr bwMode="auto">
                    <a:xfrm flipV="1">
                      <a:off x="2228851" y="901700"/>
                      <a:ext cx="0" cy="44450"/>
                    </a:xfrm>
                    <a:custGeom>
                      <a:avLst/>
                      <a:gdLst>
                        <a:gd name="T0" fmla="*/ 70 h 70"/>
                        <a:gd name="T1" fmla="*/ 0 h 70"/>
                        <a:gd name="T2" fmla="*/ 0 h 70"/>
                      </a:gdLst>
                      <a:ahLst/>
                      <a:cxnLst>
                        <a:cxn ang="0">
                          <a:pos x="0" y="T0"/>
                        </a:cxn>
                        <a:cxn ang="0">
                          <a:pos x="0" y="T1"/>
                        </a:cxn>
                        <a:cxn ang="0">
                          <a:pos x="0" y="T2"/>
                        </a:cxn>
                      </a:cxnLst>
                      <a:rect l="0" t="0" r="r" b="b"/>
                      <a:pathLst>
                        <a:path h="70">
                          <a:moveTo>
                            <a:pt x="0" y="70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" name="Line 2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201863" y="901700"/>
                      <a:ext cx="53975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" name="Rectangle 1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479676" y="873125"/>
                      <a:ext cx="301625" cy="722313"/>
                    </a:xfrm>
                    <a:prstGeom prst="rect">
                      <a:avLst/>
                    </a:prstGeom>
                    <a:solidFill>
                      <a:srgbClr val="FFFF66"/>
                    </a:solidFill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2" name="Freeform 13"/>
                    <p:cNvSpPr>
                      <a:spLocks/>
                    </p:cNvSpPr>
                    <p:nvPr/>
                  </p:nvSpPr>
                  <p:spPr bwMode="auto">
                    <a:xfrm>
                      <a:off x="2479676" y="873125"/>
                      <a:ext cx="301625" cy="722313"/>
                    </a:xfrm>
                    <a:custGeom>
                      <a:avLst/>
                      <a:gdLst>
                        <a:gd name="T0" fmla="*/ 0 w 571"/>
                        <a:gd name="T1" fmla="*/ 0 h 1366"/>
                        <a:gd name="T2" fmla="*/ 571 w 571"/>
                        <a:gd name="T3" fmla="*/ 0 h 1366"/>
                        <a:gd name="T4" fmla="*/ 571 w 571"/>
                        <a:gd name="T5" fmla="*/ 1366 h 1366"/>
                        <a:gd name="T6" fmla="*/ 0 w 571"/>
                        <a:gd name="T7" fmla="*/ 1366 h 1366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</a:cxnLst>
                      <a:rect l="0" t="0" r="r" b="b"/>
                      <a:pathLst>
                        <a:path w="571" h="1366">
                          <a:moveTo>
                            <a:pt x="0" y="0"/>
                          </a:moveTo>
                          <a:lnTo>
                            <a:pt x="571" y="0"/>
                          </a:lnTo>
                          <a:lnTo>
                            <a:pt x="571" y="1366"/>
                          </a:lnTo>
                          <a:lnTo>
                            <a:pt x="0" y="1366"/>
                          </a:lnTo>
                        </a:path>
                      </a:pathLst>
                    </a:cu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/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" name="Freeform 22"/>
                    <p:cNvSpPr>
                      <a:spLocks/>
                    </p:cNvSpPr>
                    <p:nvPr/>
                  </p:nvSpPr>
                  <p:spPr bwMode="auto">
                    <a:xfrm flipV="1">
                      <a:off x="2630488" y="596900"/>
                      <a:ext cx="0" cy="276225"/>
                    </a:xfrm>
                    <a:custGeom>
                      <a:avLst/>
                      <a:gdLst>
                        <a:gd name="T0" fmla="*/ 433 h 433"/>
                        <a:gd name="T1" fmla="*/ 0 h 433"/>
                        <a:gd name="T2" fmla="*/ 0 h 433"/>
                      </a:gdLst>
                      <a:ahLst/>
                      <a:cxnLst>
                        <a:cxn ang="0">
                          <a:pos x="0" y="T0"/>
                        </a:cxn>
                        <a:cxn ang="0">
                          <a:pos x="0" y="T1"/>
                        </a:cxn>
                        <a:cxn ang="0">
                          <a:pos x="0" y="T2"/>
                        </a:cxn>
                      </a:cxnLst>
                      <a:rect l="0" t="0" r="r" b="b"/>
                      <a:pathLst>
                        <a:path h="433">
                          <a:moveTo>
                            <a:pt x="0" y="433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solidFill>
                      <a:srgbClr val="FFFF66"/>
                    </a:solidFill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/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2" name="Line 2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03501" y="596900"/>
                      <a:ext cx="53975" cy="0"/>
                    </a:xfrm>
                    <a:prstGeom prst="line">
                      <a:avLst/>
                    </a:prstGeom>
                    <a:solidFill>
                      <a:srgbClr val="FFFF66"/>
                    </a:solidFill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/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60" name="Group 59"/>
                    <p:cNvGrpSpPr/>
                    <p:nvPr/>
                  </p:nvGrpSpPr>
                  <p:grpSpPr>
                    <a:xfrm>
                      <a:off x="2881313" y="517525"/>
                      <a:ext cx="301625" cy="1077913"/>
                      <a:chOff x="2881313" y="517525"/>
                      <a:chExt cx="301625" cy="1077913"/>
                    </a:xfrm>
                    <a:solidFill>
                      <a:srgbClr val="FFFF00"/>
                    </a:solidFill>
                  </p:grpSpPr>
                  <p:sp>
                    <p:nvSpPr>
                      <p:cNvPr id="14" name="Rectangle 1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81313" y="654050"/>
                        <a:ext cx="301625" cy="941388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5" name="Freeform 16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881313" y="654050"/>
                        <a:ext cx="301625" cy="941388"/>
                      </a:xfrm>
                      <a:custGeom>
                        <a:avLst/>
                        <a:gdLst>
                          <a:gd name="T0" fmla="*/ 0 w 570"/>
                          <a:gd name="T1" fmla="*/ 0 h 1780"/>
                          <a:gd name="T2" fmla="*/ 570 w 570"/>
                          <a:gd name="T3" fmla="*/ 0 h 1780"/>
                          <a:gd name="T4" fmla="*/ 570 w 570"/>
                          <a:gd name="T5" fmla="*/ 1780 h 1780"/>
                          <a:gd name="T6" fmla="*/ 0 w 570"/>
                          <a:gd name="T7" fmla="*/ 1780 h 1780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780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780"/>
                            </a:lnTo>
                            <a:lnTo>
                              <a:pt x="0" y="1780"/>
                            </a:lnTo>
                          </a:path>
                        </a:pathLst>
                      </a:custGeom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" name="Line 17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2881313" y="654050"/>
                        <a:ext cx="0" cy="941388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3" name="Freeform 24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3032126" y="517525"/>
                        <a:ext cx="0" cy="136525"/>
                      </a:xfrm>
                      <a:custGeom>
                        <a:avLst/>
                        <a:gdLst>
                          <a:gd name="T0" fmla="*/ 212 h 212"/>
                          <a:gd name="T1" fmla="*/ 0 h 212"/>
                          <a:gd name="T2" fmla="*/ 0 h 212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212">
                            <a:moveTo>
                              <a:pt x="0" y="212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4" name="Line 2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005138" y="517525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sp>
                  <p:nvSpPr>
                    <p:cNvPr id="26" name="Line 27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027238" y="15446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" name="Line 28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428876" y="15446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" name="Line 29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832101" y="15446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2" name="Line 3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1255713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3" name="Line 3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917575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4" name="Line 3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579438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5" name="Line 3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1482725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6" name="Line 3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1370013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7" name="Line 3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1144588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8" name="Line 3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1031875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9" name="Line 4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804863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40" name="Line 4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692150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41" name="Line 42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5601" y="466725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57" name="Rectangle 56"/>
                    <p:cNvSpPr/>
                    <p:nvPr/>
                  </p:nvSpPr>
                  <p:spPr>
                    <a:xfrm>
                      <a:off x="1625601" y="354013"/>
                      <a:ext cx="1608137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sp>
                <p:nvSpPr>
                  <p:cNvPr id="61" name="TextBox 60"/>
                  <p:cNvSpPr txBox="1"/>
                  <p:nvPr/>
                </p:nvSpPr>
                <p:spPr>
                  <a:xfrm>
                    <a:off x="1343231" y="466725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8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1" name="TextBox 70"/>
                  <p:cNvSpPr txBox="1"/>
                  <p:nvPr/>
                </p:nvSpPr>
                <p:spPr>
                  <a:xfrm>
                    <a:off x="1347464" y="809853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2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72" name="TextBox 71"/>
                  <p:cNvSpPr txBox="1"/>
                  <p:nvPr/>
                </p:nvSpPr>
                <p:spPr>
                  <a:xfrm>
                    <a:off x="1341966" y="1156156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6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1025" name="Group 1024"/>
                  <p:cNvGrpSpPr/>
                  <p:nvPr/>
                </p:nvGrpSpPr>
                <p:grpSpPr>
                  <a:xfrm>
                    <a:off x="1619464" y="1599671"/>
                    <a:ext cx="1577129" cy="367844"/>
                    <a:chOff x="1619464" y="1599671"/>
                    <a:chExt cx="1577129" cy="367844"/>
                  </a:xfrm>
                </p:grpSpPr>
                <p:sp>
                  <p:nvSpPr>
                    <p:cNvPr id="73" name="TextBox 72"/>
                    <p:cNvSpPr txBox="1"/>
                    <p:nvPr/>
                  </p:nvSpPr>
                  <p:spPr>
                    <a:xfrm>
                      <a:off x="1619464" y="1599671"/>
                      <a:ext cx="41549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4" name="TextBox 73"/>
                    <p:cNvSpPr txBox="1"/>
                    <p:nvPr/>
                  </p:nvSpPr>
                  <p:spPr>
                    <a:xfrm>
                      <a:off x="2064382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5" name="TextBox 74"/>
                    <p:cNvSpPr txBox="1"/>
                    <p:nvPr/>
                  </p:nvSpPr>
                  <p:spPr>
                    <a:xfrm>
                      <a:off x="2466321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6" name="TextBox 75"/>
                    <p:cNvSpPr txBox="1"/>
                    <p:nvPr/>
                  </p:nvSpPr>
                  <p:spPr>
                    <a:xfrm>
                      <a:off x="2867657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77" name="TextBox 76"/>
                    <p:cNvSpPr txBox="1"/>
                    <p:nvPr/>
                  </p:nvSpPr>
                  <p:spPr>
                    <a:xfrm>
                      <a:off x="2067238" y="1752071"/>
                      <a:ext cx="72327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AB30, µM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</p:grpSp>
            <p:sp>
              <p:nvSpPr>
                <p:cNvPr id="434" name="TextBox 433"/>
                <p:cNvSpPr txBox="1"/>
                <p:nvPr/>
              </p:nvSpPr>
              <p:spPr>
                <a:xfrm rot="16200000">
                  <a:off x="973631" y="878251"/>
                  <a:ext cx="73289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RAR</a:t>
                  </a:r>
                  <a:r>
                    <a:rPr lang="el-GR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γ</a:t>
                  </a:r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PIA</a:t>
                  </a:r>
                  <a:endPara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44" name="Group 443"/>
              <p:cNvGrpSpPr/>
              <p:nvPr/>
            </p:nvGrpSpPr>
            <p:grpSpPr>
              <a:xfrm>
                <a:off x="3638550" y="1143000"/>
                <a:ext cx="2000250" cy="1613502"/>
                <a:chOff x="3505200" y="354013"/>
                <a:chExt cx="2000250" cy="1613502"/>
              </a:xfrm>
            </p:grpSpPr>
            <p:grpSp>
              <p:nvGrpSpPr>
                <p:cNvPr id="436" name="Group 435"/>
                <p:cNvGrpSpPr/>
                <p:nvPr/>
              </p:nvGrpSpPr>
              <p:grpSpPr>
                <a:xfrm>
                  <a:off x="3654379" y="354013"/>
                  <a:ext cx="1851071" cy="1613502"/>
                  <a:chOff x="3509918" y="354013"/>
                  <a:chExt cx="1851071" cy="1613502"/>
                </a:xfrm>
              </p:grpSpPr>
              <p:grpSp>
                <p:nvGrpSpPr>
                  <p:cNvPr id="425" name="Group 424"/>
                  <p:cNvGrpSpPr/>
                  <p:nvPr/>
                </p:nvGrpSpPr>
                <p:grpSpPr>
                  <a:xfrm>
                    <a:off x="3752851" y="354013"/>
                    <a:ext cx="1608138" cy="1241425"/>
                    <a:chOff x="3752851" y="354013"/>
                    <a:chExt cx="1608138" cy="1241425"/>
                  </a:xfrm>
                </p:grpSpPr>
                <p:sp>
                  <p:nvSpPr>
                    <p:cNvPr id="64" name="Rectangle 61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752851" y="354013"/>
                      <a:ext cx="1608138" cy="1241425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  <a:ext uri="{91240B29-F687-4F45-9708-019B960494DF}">
                        <a14:hiddenLine xmlns:a14="http://schemas.microsoft.com/office/drawing/2010/main" w="9525">
                          <a:solidFill>
                            <a:srgbClr val="000000"/>
                          </a:solidFill>
                          <a:miter lim="800000"/>
                          <a:headEnd/>
                          <a:tailEnd/>
                        </a14:hiddenLine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1024" name="Group 1023"/>
                    <p:cNvGrpSpPr/>
                    <p:nvPr/>
                  </p:nvGrpSpPr>
                  <p:grpSpPr>
                    <a:xfrm>
                      <a:off x="3802063" y="1568450"/>
                      <a:ext cx="303213" cy="26988"/>
                      <a:chOff x="3802063" y="1568450"/>
                      <a:chExt cx="303213" cy="26988"/>
                    </a:xfrm>
                    <a:solidFill>
                      <a:srgbClr val="CC99FF"/>
                    </a:solidFill>
                  </p:grpSpPr>
                  <p:sp>
                    <p:nvSpPr>
                      <p:cNvPr id="65" name="Rectangle 6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802063" y="1577975"/>
                        <a:ext cx="303213" cy="17463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6" name="Freeform 63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802063" y="1577975"/>
                        <a:ext cx="303213" cy="17463"/>
                      </a:xfrm>
                      <a:custGeom>
                        <a:avLst/>
                        <a:gdLst>
                          <a:gd name="T0" fmla="*/ 0 w 571"/>
                          <a:gd name="T1" fmla="*/ 0 h 33"/>
                          <a:gd name="T2" fmla="*/ 571 w 571"/>
                          <a:gd name="T3" fmla="*/ 0 h 33"/>
                          <a:gd name="T4" fmla="*/ 571 w 571"/>
                          <a:gd name="T5" fmla="*/ 33 h 33"/>
                          <a:gd name="T6" fmla="*/ 0 w 571"/>
                          <a:gd name="T7" fmla="*/ 33 h 33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1" h="33">
                            <a:moveTo>
                              <a:pt x="0" y="0"/>
                            </a:moveTo>
                            <a:lnTo>
                              <a:pt x="571" y="0"/>
                            </a:lnTo>
                            <a:lnTo>
                              <a:pt x="571" y="33"/>
                            </a:lnTo>
                            <a:lnTo>
                              <a:pt x="0" y="33"/>
                            </a:lnTo>
                          </a:path>
                        </a:pathLst>
                      </a:custGeom>
                      <a:solidFill>
                        <a:schemeClr val="bg1">
                          <a:lumMod val="8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67" name="Line 64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3802063" y="1577975"/>
                        <a:ext cx="0" cy="17463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85" name="Freeform 74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3954463" y="1568450"/>
                        <a:ext cx="0" cy="9525"/>
                      </a:xfrm>
                      <a:custGeom>
                        <a:avLst/>
                        <a:gdLst>
                          <a:gd name="T0" fmla="*/ 16 h 16"/>
                          <a:gd name="T1" fmla="*/ 0 h 16"/>
                          <a:gd name="T2" fmla="*/ 0 h 16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16">
                            <a:moveTo>
                              <a:pt x="0" y="16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86" name="Line 7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927476" y="1568450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27" name="Group 126"/>
                    <p:cNvGrpSpPr/>
                    <p:nvPr/>
                  </p:nvGrpSpPr>
                  <p:grpSpPr>
                    <a:xfrm>
                      <a:off x="4205288" y="1576388"/>
                      <a:ext cx="301625" cy="19050"/>
                      <a:chOff x="4205288" y="1576388"/>
                      <a:chExt cx="301625" cy="19050"/>
                    </a:xfrm>
                    <a:solidFill>
                      <a:srgbClr val="FFFF99"/>
                    </a:solidFill>
                  </p:grpSpPr>
                  <p:sp>
                    <p:nvSpPr>
                      <p:cNvPr id="68" name="Rectangle 6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205288" y="1584325"/>
                        <a:ext cx="301625" cy="11113"/>
                      </a:xfrm>
                      <a:prstGeom prst="rect">
                        <a:avLst/>
                      </a:prstGeom>
                      <a:solidFill>
                        <a:schemeClr val="bg1">
                          <a:lumMod val="65000"/>
                        </a:schemeClr>
                      </a:solidFill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70" name="Freeform 66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4205288" y="1584325"/>
                        <a:ext cx="301625" cy="11113"/>
                      </a:xfrm>
                      <a:custGeom>
                        <a:avLst/>
                        <a:gdLst>
                          <a:gd name="T0" fmla="*/ 0 w 570"/>
                          <a:gd name="T1" fmla="*/ 0 h 21"/>
                          <a:gd name="T2" fmla="*/ 570 w 570"/>
                          <a:gd name="T3" fmla="*/ 0 h 21"/>
                          <a:gd name="T4" fmla="*/ 570 w 570"/>
                          <a:gd name="T5" fmla="*/ 21 h 21"/>
                          <a:gd name="T6" fmla="*/ 0 w 570"/>
                          <a:gd name="T7" fmla="*/ 21 h 21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21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21"/>
                            </a:lnTo>
                            <a:lnTo>
                              <a:pt x="0" y="21"/>
                            </a:lnTo>
                          </a:path>
                        </a:pathLst>
                      </a:custGeom>
                      <a:solidFill>
                        <a:schemeClr val="bg1">
                          <a:lumMod val="6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78" name="Line 67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4205288" y="1584325"/>
                        <a:ext cx="0" cy="11113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87" name="Freeform 76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356101" y="1576388"/>
                        <a:ext cx="0" cy="7938"/>
                      </a:xfrm>
                      <a:custGeom>
                        <a:avLst/>
                        <a:gdLst>
                          <a:gd name="T0" fmla="*/ 12 h 12"/>
                          <a:gd name="T1" fmla="*/ 0 h 12"/>
                          <a:gd name="T2" fmla="*/ 0 h 12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12">
                            <a:moveTo>
                              <a:pt x="0" y="12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88" name="Line 7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329113" y="1576388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26" name="Group 125"/>
                    <p:cNvGrpSpPr/>
                    <p:nvPr/>
                  </p:nvGrpSpPr>
                  <p:grpSpPr>
                    <a:xfrm>
                      <a:off x="4606926" y="1512888"/>
                      <a:ext cx="301625" cy="82550"/>
                      <a:chOff x="4606926" y="1512888"/>
                      <a:chExt cx="301625" cy="82550"/>
                    </a:xfrm>
                    <a:solidFill>
                      <a:srgbClr val="FFFF66"/>
                    </a:solidFill>
                  </p:grpSpPr>
                  <p:sp>
                    <p:nvSpPr>
                      <p:cNvPr id="79" name="Rectangle 6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06926" y="1544638"/>
                        <a:ext cx="301625" cy="5080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80" name="Freeform 69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4606926" y="1544638"/>
                        <a:ext cx="301625" cy="50800"/>
                      </a:xfrm>
                      <a:custGeom>
                        <a:avLst/>
                        <a:gdLst>
                          <a:gd name="T0" fmla="*/ 0 w 570"/>
                          <a:gd name="T1" fmla="*/ 0 h 95"/>
                          <a:gd name="T2" fmla="*/ 570 w 570"/>
                          <a:gd name="T3" fmla="*/ 0 h 95"/>
                          <a:gd name="T4" fmla="*/ 570 w 570"/>
                          <a:gd name="T5" fmla="*/ 95 h 95"/>
                          <a:gd name="T6" fmla="*/ 0 w 570"/>
                          <a:gd name="T7" fmla="*/ 95 h 95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95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95"/>
                            </a:lnTo>
                            <a:lnTo>
                              <a:pt x="0" y="95"/>
                            </a:lnTo>
                          </a:path>
                        </a:pathLst>
                      </a:cu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81" name="Line 70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4606926" y="1544638"/>
                        <a:ext cx="0" cy="5080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89" name="Freeform 78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757738" y="1512888"/>
                        <a:ext cx="0" cy="31750"/>
                      </a:xfrm>
                      <a:custGeom>
                        <a:avLst/>
                        <a:gdLst>
                          <a:gd name="T0" fmla="*/ 49 h 49"/>
                          <a:gd name="T1" fmla="*/ 0 h 49"/>
                          <a:gd name="T2" fmla="*/ 0 h 49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49">
                            <a:moveTo>
                              <a:pt x="0" y="49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90" name="Line 7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730751" y="1512888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25" name="Group 124"/>
                    <p:cNvGrpSpPr/>
                    <p:nvPr/>
                  </p:nvGrpSpPr>
                  <p:grpSpPr>
                    <a:xfrm>
                      <a:off x="5008563" y="519113"/>
                      <a:ext cx="301625" cy="1076325"/>
                      <a:chOff x="5008563" y="519113"/>
                      <a:chExt cx="301625" cy="1076325"/>
                    </a:xfrm>
                    <a:solidFill>
                      <a:srgbClr val="FFFF00"/>
                    </a:solidFill>
                  </p:grpSpPr>
                  <p:sp>
                    <p:nvSpPr>
                      <p:cNvPr id="82" name="Rectangle 7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5008563" y="847725"/>
                        <a:ext cx="301625" cy="747713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83" name="Freeform 72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5008563" y="847725"/>
                        <a:ext cx="301625" cy="747713"/>
                      </a:xfrm>
                      <a:custGeom>
                        <a:avLst/>
                        <a:gdLst>
                          <a:gd name="T0" fmla="*/ 0 w 570"/>
                          <a:gd name="T1" fmla="*/ 0 h 1414"/>
                          <a:gd name="T2" fmla="*/ 570 w 570"/>
                          <a:gd name="T3" fmla="*/ 0 h 1414"/>
                          <a:gd name="T4" fmla="*/ 570 w 570"/>
                          <a:gd name="T5" fmla="*/ 1414 h 1414"/>
                          <a:gd name="T6" fmla="*/ 0 w 570"/>
                          <a:gd name="T7" fmla="*/ 1414 h 1414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414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414"/>
                            </a:lnTo>
                            <a:lnTo>
                              <a:pt x="0" y="1414"/>
                            </a:lnTo>
                          </a:path>
                        </a:pathLst>
                      </a:custGeom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84" name="Line 73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5008563" y="847725"/>
                        <a:ext cx="0" cy="747713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91" name="Freeform 80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5159376" y="519113"/>
                        <a:ext cx="0" cy="328613"/>
                      </a:xfrm>
                      <a:custGeom>
                        <a:avLst/>
                        <a:gdLst>
                          <a:gd name="T0" fmla="*/ 513 h 513"/>
                          <a:gd name="T1" fmla="*/ 0 h 513"/>
                          <a:gd name="T2" fmla="*/ 0 h 513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513">
                            <a:moveTo>
                              <a:pt x="0" y="513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92" name="Line 8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132388" y="519113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sp>
                  <p:nvSpPr>
                    <p:cNvPr id="93" name="Line 82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3752851" y="15446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4" name="Line 83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154488" y="15446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5" name="Line 84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556126" y="15446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6" name="Line 85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959351" y="15446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7" name="Line 86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5360988" y="15446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99" name="Line 8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1595438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0" name="Line 8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1319213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1" name="Line 9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1044575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2" name="Line 9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76835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3" name="Line 92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492125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4" name="Line 9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1457325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5" name="Line 9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1181100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6" name="Line 9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906463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7" name="Line 9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630238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8" name="Line 9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752851" y="354013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rgbClr val="646464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34" name="Rectangle 133"/>
                    <p:cNvSpPr/>
                    <p:nvPr/>
                  </p:nvSpPr>
                  <p:spPr>
                    <a:xfrm>
                      <a:off x="3752851" y="354013"/>
                      <a:ext cx="1608137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grpSp>
                <p:nvGrpSpPr>
                  <p:cNvPr id="140" name="Group 139"/>
                  <p:cNvGrpSpPr/>
                  <p:nvPr/>
                </p:nvGrpSpPr>
                <p:grpSpPr>
                  <a:xfrm>
                    <a:off x="3767561" y="1599671"/>
                    <a:ext cx="1577129" cy="367844"/>
                    <a:chOff x="1619464" y="1599671"/>
                    <a:chExt cx="1577129" cy="367844"/>
                  </a:xfrm>
                </p:grpSpPr>
                <p:sp>
                  <p:nvSpPr>
                    <p:cNvPr id="141" name="TextBox 140"/>
                    <p:cNvSpPr txBox="1"/>
                    <p:nvPr/>
                  </p:nvSpPr>
                  <p:spPr>
                    <a:xfrm>
                      <a:off x="1619464" y="1599671"/>
                      <a:ext cx="41549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2" name="TextBox 141"/>
                    <p:cNvSpPr txBox="1"/>
                    <p:nvPr/>
                  </p:nvSpPr>
                  <p:spPr>
                    <a:xfrm>
                      <a:off x="2064382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3" name="TextBox 142"/>
                    <p:cNvSpPr txBox="1"/>
                    <p:nvPr/>
                  </p:nvSpPr>
                  <p:spPr>
                    <a:xfrm>
                      <a:off x="2466321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4" name="TextBox 143"/>
                    <p:cNvSpPr txBox="1"/>
                    <p:nvPr/>
                  </p:nvSpPr>
                  <p:spPr>
                    <a:xfrm>
                      <a:off x="2867657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145" name="TextBox 144"/>
                    <p:cNvSpPr txBox="1"/>
                    <p:nvPr/>
                  </p:nvSpPr>
                  <p:spPr>
                    <a:xfrm>
                      <a:off x="2067238" y="1752071"/>
                      <a:ext cx="72327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AB30, µM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34" name="TextBox 533"/>
                  <p:cNvSpPr txBox="1"/>
                  <p:nvPr/>
                </p:nvSpPr>
                <p:spPr>
                  <a:xfrm>
                    <a:off x="3509918" y="384403"/>
                    <a:ext cx="30008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0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5" name="TextBox 534"/>
                  <p:cNvSpPr txBox="1"/>
                  <p:nvPr/>
                </p:nvSpPr>
                <p:spPr>
                  <a:xfrm>
                    <a:off x="3509918" y="659119"/>
                    <a:ext cx="30008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6" name="TextBox 535"/>
                  <p:cNvSpPr txBox="1"/>
                  <p:nvPr/>
                </p:nvSpPr>
                <p:spPr>
                  <a:xfrm>
                    <a:off x="3509918" y="941876"/>
                    <a:ext cx="30008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7" name="TextBox 536"/>
                  <p:cNvSpPr txBox="1"/>
                  <p:nvPr/>
                </p:nvSpPr>
                <p:spPr>
                  <a:xfrm>
                    <a:off x="3509918" y="1205934"/>
                    <a:ext cx="30008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65" name="TextBox 564"/>
                <p:cNvSpPr txBox="1"/>
                <p:nvPr/>
              </p:nvSpPr>
              <p:spPr>
                <a:xfrm rot="16200000">
                  <a:off x="3269719" y="878251"/>
                  <a:ext cx="686406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MUC</a:t>
                  </a:r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PIA</a:t>
                  </a:r>
                  <a:endPara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46" name="Group 445"/>
              <p:cNvGrpSpPr/>
              <p:nvPr/>
            </p:nvGrpSpPr>
            <p:grpSpPr>
              <a:xfrm>
                <a:off x="3638550" y="2764232"/>
                <a:ext cx="2000250" cy="1731568"/>
                <a:chOff x="3505200" y="2077472"/>
                <a:chExt cx="2000250" cy="1731568"/>
              </a:xfrm>
            </p:grpSpPr>
            <p:grpSp>
              <p:nvGrpSpPr>
                <p:cNvPr id="438" name="Group 437"/>
                <p:cNvGrpSpPr/>
                <p:nvPr/>
              </p:nvGrpSpPr>
              <p:grpSpPr>
                <a:xfrm>
                  <a:off x="3616000" y="2077472"/>
                  <a:ext cx="1889450" cy="1731568"/>
                  <a:chOff x="3557264" y="2077472"/>
                  <a:chExt cx="1889450" cy="1731568"/>
                </a:xfrm>
              </p:grpSpPr>
              <p:grpSp>
                <p:nvGrpSpPr>
                  <p:cNvPr id="429" name="Group 428"/>
                  <p:cNvGrpSpPr/>
                  <p:nvPr/>
                </p:nvGrpSpPr>
                <p:grpSpPr>
                  <a:xfrm>
                    <a:off x="3837782" y="2182813"/>
                    <a:ext cx="1608932" cy="1243806"/>
                    <a:chOff x="3837782" y="2182813"/>
                    <a:chExt cx="1608932" cy="1243806"/>
                  </a:xfrm>
                </p:grpSpPr>
                <p:sp>
                  <p:nvSpPr>
                    <p:cNvPr id="133" name="Rectangle 132"/>
                    <p:cNvSpPr/>
                    <p:nvPr/>
                  </p:nvSpPr>
                  <p:spPr>
                    <a:xfrm>
                      <a:off x="3837782" y="2185194"/>
                      <a:ext cx="1608137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036" name="Rectangle 117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38576" y="2182813"/>
                      <a:ext cx="1608138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136" name="Group 135"/>
                    <p:cNvGrpSpPr/>
                    <p:nvPr/>
                  </p:nvGrpSpPr>
                  <p:grpSpPr>
                    <a:xfrm>
                      <a:off x="3887788" y="2735263"/>
                      <a:ext cx="303213" cy="688975"/>
                      <a:chOff x="3887788" y="2735263"/>
                      <a:chExt cx="303213" cy="688975"/>
                    </a:xfrm>
                    <a:solidFill>
                      <a:srgbClr val="CC99FF"/>
                    </a:solidFill>
                  </p:grpSpPr>
                  <p:sp>
                    <p:nvSpPr>
                      <p:cNvPr id="1037" name="Rectangle 11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887788" y="2803525"/>
                        <a:ext cx="303213" cy="620713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38" name="Freeform 119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887788" y="2803525"/>
                        <a:ext cx="303213" cy="620713"/>
                      </a:xfrm>
                      <a:custGeom>
                        <a:avLst/>
                        <a:gdLst>
                          <a:gd name="T0" fmla="*/ 0 w 571"/>
                          <a:gd name="T1" fmla="*/ 0 h 1173"/>
                          <a:gd name="T2" fmla="*/ 571 w 571"/>
                          <a:gd name="T3" fmla="*/ 0 h 1173"/>
                          <a:gd name="T4" fmla="*/ 571 w 571"/>
                          <a:gd name="T5" fmla="*/ 1173 h 1173"/>
                          <a:gd name="T6" fmla="*/ 0 w 571"/>
                          <a:gd name="T7" fmla="*/ 1173 h 1173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1" h="1173">
                            <a:moveTo>
                              <a:pt x="0" y="0"/>
                            </a:moveTo>
                            <a:lnTo>
                              <a:pt x="571" y="0"/>
                            </a:lnTo>
                            <a:lnTo>
                              <a:pt x="571" y="1173"/>
                            </a:lnTo>
                            <a:lnTo>
                              <a:pt x="0" y="1173"/>
                            </a:lnTo>
                          </a:path>
                        </a:pathLst>
                      </a:custGeom>
                      <a:solidFill>
                        <a:schemeClr val="bg1">
                          <a:lumMod val="8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39" name="Line 120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3887788" y="2803525"/>
                        <a:ext cx="0" cy="620713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49" name="Freeform 130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040188" y="2735263"/>
                        <a:ext cx="0" cy="68263"/>
                      </a:xfrm>
                      <a:custGeom>
                        <a:avLst/>
                        <a:gdLst>
                          <a:gd name="T0" fmla="*/ 107 h 107"/>
                          <a:gd name="T1" fmla="*/ 0 h 107"/>
                          <a:gd name="T2" fmla="*/ 0 h 107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107">
                            <a:moveTo>
                              <a:pt x="0" y="107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50" name="Line 13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13201" y="2735263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35" name="Group 134"/>
                    <p:cNvGrpSpPr/>
                    <p:nvPr/>
                  </p:nvGrpSpPr>
                  <p:grpSpPr>
                    <a:xfrm>
                      <a:off x="4291013" y="2312988"/>
                      <a:ext cx="301625" cy="1111250"/>
                      <a:chOff x="4291013" y="2312988"/>
                      <a:chExt cx="301625" cy="1111250"/>
                    </a:xfrm>
                    <a:solidFill>
                      <a:srgbClr val="FFFF99"/>
                    </a:solidFill>
                  </p:grpSpPr>
                  <p:sp>
                    <p:nvSpPr>
                      <p:cNvPr id="1040" name="Rectangle 12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291013" y="2586038"/>
                        <a:ext cx="301625" cy="83820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41" name="Freeform 122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4291013" y="2586038"/>
                        <a:ext cx="301625" cy="838200"/>
                      </a:xfrm>
                      <a:custGeom>
                        <a:avLst/>
                        <a:gdLst>
                          <a:gd name="T0" fmla="*/ 0 w 570"/>
                          <a:gd name="T1" fmla="*/ 0 h 1584"/>
                          <a:gd name="T2" fmla="*/ 570 w 570"/>
                          <a:gd name="T3" fmla="*/ 0 h 1584"/>
                          <a:gd name="T4" fmla="*/ 570 w 570"/>
                          <a:gd name="T5" fmla="*/ 1584 h 1584"/>
                          <a:gd name="T6" fmla="*/ 0 w 570"/>
                          <a:gd name="T7" fmla="*/ 1584 h 1584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584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584"/>
                            </a:lnTo>
                            <a:lnTo>
                              <a:pt x="0" y="1584"/>
                            </a:lnTo>
                          </a:path>
                        </a:pathLst>
                      </a:custGeom>
                      <a:solidFill>
                        <a:schemeClr val="bg1">
                          <a:lumMod val="6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42" name="Line 123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4291013" y="2586038"/>
                        <a:ext cx="0" cy="83820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51" name="Freeform 132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441826" y="2312988"/>
                        <a:ext cx="0" cy="273050"/>
                      </a:xfrm>
                      <a:custGeom>
                        <a:avLst/>
                        <a:gdLst>
                          <a:gd name="T0" fmla="*/ 427 h 427"/>
                          <a:gd name="T1" fmla="*/ 0 h 427"/>
                          <a:gd name="T2" fmla="*/ 0 h 427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427">
                            <a:moveTo>
                              <a:pt x="0" y="427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52" name="Line 13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14838" y="2312988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32" name="Group 131"/>
                    <p:cNvGrpSpPr/>
                    <p:nvPr/>
                  </p:nvGrpSpPr>
                  <p:grpSpPr>
                    <a:xfrm>
                      <a:off x="4692651" y="2425700"/>
                      <a:ext cx="301625" cy="998538"/>
                      <a:chOff x="4692651" y="2425700"/>
                      <a:chExt cx="301625" cy="998538"/>
                    </a:xfrm>
                    <a:solidFill>
                      <a:srgbClr val="FFFF66"/>
                    </a:solidFill>
                  </p:grpSpPr>
                  <p:sp>
                    <p:nvSpPr>
                      <p:cNvPr id="1043" name="Rectangle 12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92651" y="2716213"/>
                        <a:ext cx="301625" cy="708025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44" name="Freeform 125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4692651" y="2716213"/>
                        <a:ext cx="301625" cy="708025"/>
                      </a:xfrm>
                      <a:custGeom>
                        <a:avLst/>
                        <a:gdLst>
                          <a:gd name="T0" fmla="*/ 0 w 570"/>
                          <a:gd name="T1" fmla="*/ 0 h 1338"/>
                          <a:gd name="T2" fmla="*/ 570 w 570"/>
                          <a:gd name="T3" fmla="*/ 0 h 1338"/>
                          <a:gd name="T4" fmla="*/ 570 w 570"/>
                          <a:gd name="T5" fmla="*/ 1338 h 1338"/>
                          <a:gd name="T6" fmla="*/ 0 w 570"/>
                          <a:gd name="T7" fmla="*/ 1338 h 1338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338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338"/>
                            </a:lnTo>
                            <a:lnTo>
                              <a:pt x="0" y="1338"/>
                            </a:lnTo>
                          </a:path>
                        </a:pathLst>
                      </a:cu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45" name="Line 126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4692651" y="2716213"/>
                        <a:ext cx="0" cy="708025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53" name="Freeform 134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843463" y="2425700"/>
                        <a:ext cx="0" cy="290513"/>
                      </a:xfrm>
                      <a:custGeom>
                        <a:avLst/>
                        <a:gdLst>
                          <a:gd name="T0" fmla="*/ 456 h 456"/>
                          <a:gd name="T1" fmla="*/ 0 h 456"/>
                          <a:gd name="T2" fmla="*/ 0 h 456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456">
                            <a:moveTo>
                              <a:pt x="0" y="456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54" name="Line 13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816476" y="2425700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31" name="Group 130"/>
                    <p:cNvGrpSpPr/>
                    <p:nvPr/>
                  </p:nvGrpSpPr>
                  <p:grpSpPr>
                    <a:xfrm>
                      <a:off x="5094288" y="3089275"/>
                      <a:ext cx="301625" cy="334963"/>
                      <a:chOff x="5094288" y="3089275"/>
                      <a:chExt cx="301625" cy="334963"/>
                    </a:xfrm>
                    <a:solidFill>
                      <a:srgbClr val="FFFF00"/>
                    </a:solidFill>
                  </p:grpSpPr>
                  <p:sp>
                    <p:nvSpPr>
                      <p:cNvPr id="1046" name="Rectangle 12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5094288" y="3144838"/>
                        <a:ext cx="301625" cy="27940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47" name="Freeform 128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5094288" y="3144838"/>
                        <a:ext cx="301625" cy="279400"/>
                      </a:xfrm>
                      <a:custGeom>
                        <a:avLst/>
                        <a:gdLst>
                          <a:gd name="T0" fmla="*/ 0 w 570"/>
                          <a:gd name="T1" fmla="*/ 0 h 528"/>
                          <a:gd name="T2" fmla="*/ 570 w 570"/>
                          <a:gd name="T3" fmla="*/ 0 h 528"/>
                          <a:gd name="T4" fmla="*/ 570 w 570"/>
                          <a:gd name="T5" fmla="*/ 528 h 528"/>
                          <a:gd name="T6" fmla="*/ 0 w 570"/>
                          <a:gd name="T7" fmla="*/ 528 h 528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528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528"/>
                            </a:lnTo>
                            <a:lnTo>
                              <a:pt x="0" y="528"/>
                            </a:lnTo>
                          </a:path>
                        </a:pathLst>
                      </a:custGeom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48" name="Line 129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5094288" y="3144838"/>
                        <a:ext cx="0" cy="27940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55" name="Freeform 136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5245101" y="3089275"/>
                        <a:ext cx="0" cy="55563"/>
                      </a:xfrm>
                      <a:custGeom>
                        <a:avLst/>
                        <a:gdLst>
                          <a:gd name="T0" fmla="*/ 87 h 87"/>
                          <a:gd name="T1" fmla="*/ 0 h 87"/>
                          <a:gd name="T2" fmla="*/ 0 h 87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87">
                            <a:moveTo>
                              <a:pt x="0" y="87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56" name="Line 13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218113" y="3089275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sp>
                  <p:nvSpPr>
                    <p:cNvPr id="1058" name="Line 139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240213" y="33734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59" name="Line 140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641851" y="33734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60" name="Line 141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5045076" y="33734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64" name="Line 14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3176588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65" name="Line 14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292735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66" name="Line 14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267970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67" name="Line 14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2430463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69" name="Line 15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3300413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70" name="Line 15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3051175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71" name="Line 152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2803525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72" name="Line 15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2555875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073" name="Line 15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2306638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</p:grpSp>
              <p:grpSp>
                <p:nvGrpSpPr>
                  <p:cNvPr id="522" name="Group 521"/>
                  <p:cNvGrpSpPr/>
                  <p:nvPr/>
                </p:nvGrpSpPr>
                <p:grpSpPr>
                  <a:xfrm>
                    <a:off x="3853286" y="3441196"/>
                    <a:ext cx="1577129" cy="367844"/>
                    <a:chOff x="1619464" y="1599671"/>
                    <a:chExt cx="1577129" cy="367844"/>
                  </a:xfrm>
                </p:grpSpPr>
                <p:sp>
                  <p:nvSpPr>
                    <p:cNvPr id="523" name="TextBox 522"/>
                    <p:cNvSpPr txBox="1"/>
                    <p:nvPr/>
                  </p:nvSpPr>
                  <p:spPr>
                    <a:xfrm>
                      <a:off x="1619464" y="1599671"/>
                      <a:ext cx="41549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4" name="TextBox 523"/>
                    <p:cNvSpPr txBox="1"/>
                    <p:nvPr/>
                  </p:nvSpPr>
                  <p:spPr>
                    <a:xfrm>
                      <a:off x="2064382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5" name="TextBox 524"/>
                    <p:cNvSpPr txBox="1"/>
                    <p:nvPr/>
                  </p:nvSpPr>
                  <p:spPr>
                    <a:xfrm>
                      <a:off x="2466321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6" name="TextBox 525"/>
                    <p:cNvSpPr txBox="1"/>
                    <p:nvPr/>
                  </p:nvSpPr>
                  <p:spPr>
                    <a:xfrm>
                      <a:off x="2867657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7" name="TextBox 526"/>
                    <p:cNvSpPr txBox="1"/>
                    <p:nvPr/>
                  </p:nvSpPr>
                  <p:spPr>
                    <a:xfrm>
                      <a:off x="2067238" y="1752071"/>
                      <a:ext cx="72327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AB30, µM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54" name="TextBox 553"/>
                  <p:cNvSpPr txBox="1"/>
                  <p:nvPr/>
                </p:nvSpPr>
                <p:spPr>
                  <a:xfrm>
                    <a:off x="3557264" y="2077472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.0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5" name="TextBox 554"/>
                  <p:cNvSpPr txBox="1"/>
                  <p:nvPr/>
                </p:nvSpPr>
                <p:spPr>
                  <a:xfrm>
                    <a:off x="3557264" y="2327811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6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6" name="TextBox 555"/>
                  <p:cNvSpPr txBox="1"/>
                  <p:nvPr/>
                </p:nvSpPr>
                <p:spPr>
                  <a:xfrm>
                    <a:off x="3557264" y="2575016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2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7" name="TextBox 556"/>
                  <p:cNvSpPr txBox="1"/>
                  <p:nvPr/>
                </p:nvSpPr>
                <p:spPr>
                  <a:xfrm>
                    <a:off x="3557264" y="2822010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8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8" name="TextBox 557"/>
                  <p:cNvSpPr txBox="1"/>
                  <p:nvPr/>
                </p:nvSpPr>
                <p:spPr>
                  <a:xfrm>
                    <a:off x="3557264" y="3068866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4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66" name="TextBox 565"/>
                <p:cNvSpPr txBox="1"/>
                <p:nvPr/>
              </p:nvSpPr>
              <p:spPr>
                <a:xfrm rot="16200000">
                  <a:off x="3283344" y="2652673"/>
                  <a:ext cx="65915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FLG</a:t>
                  </a:r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PIA</a:t>
                  </a:r>
                  <a:endPara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45" name="Group 444"/>
              <p:cNvGrpSpPr/>
              <p:nvPr/>
            </p:nvGrpSpPr>
            <p:grpSpPr>
              <a:xfrm>
                <a:off x="1232356" y="2869573"/>
                <a:ext cx="2031017" cy="1626227"/>
                <a:chOff x="1232356" y="2182813"/>
                <a:chExt cx="2031017" cy="1626227"/>
              </a:xfrm>
            </p:grpSpPr>
            <p:grpSp>
              <p:nvGrpSpPr>
                <p:cNvPr id="437" name="Group 436"/>
                <p:cNvGrpSpPr/>
                <p:nvPr/>
              </p:nvGrpSpPr>
              <p:grpSpPr>
                <a:xfrm>
                  <a:off x="1401720" y="2182813"/>
                  <a:ext cx="1861653" cy="1626227"/>
                  <a:chOff x="1376318" y="2182813"/>
                  <a:chExt cx="1861653" cy="1626227"/>
                </a:xfrm>
              </p:grpSpPr>
              <p:grpSp>
                <p:nvGrpSpPr>
                  <p:cNvPr id="428" name="Group 427"/>
                  <p:cNvGrpSpPr/>
                  <p:nvPr/>
                </p:nvGrpSpPr>
                <p:grpSpPr>
                  <a:xfrm>
                    <a:off x="1627188" y="2182813"/>
                    <a:ext cx="1610783" cy="1241425"/>
                    <a:chOff x="1627188" y="2182813"/>
                    <a:chExt cx="1610783" cy="1241425"/>
                  </a:xfrm>
                </p:grpSpPr>
                <p:sp>
                  <p:nvSpPr>
                    <p:cNvPr id="207" name="Rectangle 206"/>
                    <p:cNvSpPr/>
                    <p:nvPr/>
                  </p:nvSpPr>
                  <p:spPr>
                    <a:xfrm>
                      <a:off x="1629834" y="2182813"/>
                      <a:ext cx="1608137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39" name="Rectangle 17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627188" y="2182813"/>
                      <a:ext cx="1608138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195" name="Group 194"/>
                    <p:cNvGrpSpPr/>
                    <p:nvPr/>
                  </p:nvGrpSpPr>
                  <p:grpSpPr>
                    <a:xfrm>
                      <a:off x="1676400" y="3365500"/>
                      <a:ext cx="303213" cy="58738"/>
                      <a:chOff x="1676400" y="3365500"/>
                      <a:chExt cx="303213" cy="58738"/>
                    </a:xfrm>
                    <a:solidFill>
                      <a:srgbClr val="CC99FF"/>
                    </a:solidFill>
                  </p:grpSpPr>
                  <p:sp>
                    <p:nvSpPr>
                      <p:cNvPr id="146" name="Rectangle 176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676400" y="3381375"/>
                        <a:ext cx="303213" cy="42863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47" name="Freeform 177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676400" y="3381375"/>
                        <a:ext cx="303213" cy="42863"/>
                      </a:xfrm>
                      <a:custGeom>
                        <a:avLst/>
                        <a:gdLst>
                          <a:gd name="T0" fmla="*/ 0 w 571"/>
                          <a:gd name="T1" fmla="*/ 0 h 82"/>
                          <a:gd name="T2" fmla="*/ 571 w 571"/>
                          <a:gd name="T3" fmla="*/ 0 h 82"/>
                          <a:gd name="T4" fmla="*/ 571 w 571"/>
                          <a:gd name="T5" fmla="*/ 82 h 82"/>
                          <a:gd name="T6" fmla="*/ 0 w 571"/>
                          <a:gd name="T7" fmla="*/ 82 h 82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1" h="82">
                            <a:moveTo>
                              <a:pt x="0" y="0"/>
                            </a:moveTo>
                            <a:lnTo>
                              <a:pt x="571" y="0"/>
                            </a:lnTo>
                            <a:lnTo>
                              <a:pt x="571" y="82"/>
                            </a:lnTo>
                            <a:lnTo>
                              <a:pt x="0" y="82"/>
                            </a:lnTo>
                          </a:path>
                        </a:pathLst>
                      </a:custGeom>
                      <a:solidFill>
                        <a:schemeClr val="bg1">
                          <a:lumMod val="8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48" name="Line 178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1676400" y="3381375"/>
                        <a:ext cx="0" cy="42863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58" name="Freeform 188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1828800" y="3365500"/>
                        <a:ext cx="0" cy="15875"/>
                      </a:xfrm>
                      <a:custGeom>
                        <a:avLst/>
                        <a:gdLst>
                          <a:gd name="T0" fmla="*/ 24 h 24"/>
                          <a:gd name="T1" fmla="*/ 0 h 24"/>
                          <a:gd name="T2" fmla="*/ 0 h 24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24">
                            <a:moveTo>
                              <a:pt x="0" y="24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59" name="Line 18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801813" y="3365500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96" name="Group 195"/>
                    <p:cNvGrpSpPr/>
                    <p:nvPr/>
                  </p:nvGrpSpPr>
                  <p:grpSpPr>
                    <a:xfrm>
                      <a:off x="2079625" y="3336925"/>
                      <a:ext cx="301625" cy="87313"/>
                      <a:chOff x="2079625" y="3336925"/>
                      <a:chExt cx="301625" cy="87313"/>
                    </a:xfrm>
                    <a:solidFill>
                      <a:srgbClr val="FFFF99"/>
                    </a:solidFill>
                  </p:grpSpPr>
                  <p:sp>
                    <p:nvSpPr>
                      <p:cNvPr id="149" name="Rectangle 17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079625" y="3375025"/>
                        <a:ext cx="301625" cy="49213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50" name="Freeform 180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079625" y="3375025"/>
                        <a:ext cx="301625" cy="49213"/>
                      </a:xfrm>
                      <a:custGeom>
                        <a:avLst/>
                        <a:gdLst>
                          <a:gd name="T0" fmla="*/ 0 w 570"/>
                          <a:gd name="T1" fmla="*/ 0 h 93"/>
                          <a:gd name="T2" fmla="*/ 570 w 570"/>
                          <a:gd name="T3" fmla="*/ 0 h 93"/>
                          <a:gd name="T4" fmla="*/ 570 w 570"/>
                          <a:gd name="T5" fmla="*/ 93 h 93"/>
                          <a:gd name="T6" fmla="*/ 0 w 570"/>
                          <a:gd name="T7" fmla="*/ 93 h 93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93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93"/>
                            </a:lnTo>
                            <a:lnTo>
                              <a:pt x="0" y="93"/>
                            </a:lnTo>
                          </a:path>
                        </a:pathLst>
                      </a:custGeom>
                      <a:solidFill>
                        <a:schemeClr val="bg1">
                          <a:lumMod val="6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51" name="Line 181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2079625" y="3375025"/>
                        <a:ext cx="0" cy="49213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0" name="Freeform 190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2230438" y="3336925"/>
                        <a:ext cx="0" cy="38100"/>
                      </a:xfrm>
                      <a:custGeom>
                        <a:avLst/>
                        <a:gdLst>
                          <a:gd name="T0" fmla="*/ 60 h 60"/>
                          <a:gd name="T1" fmla="*/ 0 h 60"/>
                          <a:gd name="T2" fmla="*/ 0 h 60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60">
                            <a:moveTo>
                              <a:pt x="0" y="60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1" name="Line 19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203450" y="3336925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97" name="Group 196"/>
                    <p:cNvGrpSpPr/>
                    <p:nvPr/>
                  </p:nvGrpSpPr>
                  <p:grpSpPr>
                    <a:xfrm>
                      <a:off x="2481263" y="3346450"/>
                      <a:ext cx="301625" cy="77788"/>
                      <a:chOff x="2481263" y="3346450"/>
                      <a:chExt cx="301625" cy="77788"/>
                    </a:xfrm>
                    <a:solidFill>
                      <a:srgbClr val="FFFF66"/>
                    </a:solidFill>
                  </p:grpSpPr>
                  <p:sp>
                    <p:nvSpPr>
                      <p:cNvPr id="152" name="Rectangle 18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481263" y="3378200"/>
                        <a:ext cx="301625" cy="46038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53" name="Freeform 183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481263" y="3378200"/>
                        <a:ext cx="301625" cy="46038"/>
                      </a:xfrm>
                      <a:custGeom>
                        <a:avLst/>
                        <a:gdLst>
                          <a:gd name="T0" fmla="*/ 0 w 570"/>
                          <a:gd name="T1" fmla="*/ 0 h 87"/>
                          <a:gd name="T2" fmla="*/ 570 w 570"/>
                          <a:gd name="T3" fmla="*/ 0 h 87"/>
                          <a:gd name="T4" fmla="*/ 570 w 570"/>
                          <a:gd name="T5" fmla="*/ 87 h 87"/>
                          <a:gd name="T6" fmla="*/ 0 w 570"/>
                          <a:gd name="T7" fmla="*/ 87 h 87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87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87"/>
                            </a:lnTo>
                            <a:lnTo>
                              <a:pt x="0" y="87"/>
                            </a:lnTo>
                          </a:path>
                        </a:pathLst>
                      </a:cu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54" name="Line 184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2481263" y="3378200"/>
                        <a:ext cx="0" cy="46038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2" name="Freeform 192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2632075" y="3346450"/>
                        <a:ext cx="0" cy="31750"/>
                      </a:xfrm>
                      <a:custGeom>
                        <a:avLst/>
                        <a:gdLst>
                          <a:gd name="T0" fmla="*/ 50 h 50"/>
                          <a:gd name="T1" fmla="*/ 0 h 50"/>
                          <a:gd name="T2" fmla="*/ 0 h 50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50">
                            <a:moveTo>
                              <a:pt x="0" y="50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3" name="Line 19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605088" y="3346450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98" name="Group 197"/>
                    <p:cNvGrpSpPr/>
                    <p:nvPr/>
                  </p:nvGrpSpPr>
                  <p:grpSpPr>
                    <a:xfrm>
                      <a:off x="2882900" y="2362200"/>
                      <a:ext cx="301625" cy="1062038"/>
                      <a:chOff x="2882900" y="2362200"/>
                      <a:chExt cx="301625" cy="1062038"/>
                    </a:xfrm>
                    <a:solidFill>
                      <a:srgbClr val="FFFF00"/>
                    </a:solidFill>
                  </p:grpSpPr>
                  <p:sp>
                    <p:nvSpPr>
                      <p:cNvPr id="155" name="Rectangle 18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882900" y="2484438"/>
                        <a:ext cx="301625" cy="93980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56" name="Freeform 186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882900" y="2484438"/>
                        <a:ext cx="301625" cy="939800"/>
                      </a:xfrm>
                      <a:custGeom>
                        <a:avLst/>
                        <a:gdLst>
                          <a:gd name="T0" fmla="*/ 0 w 570"/>
                          <a:gd name="T1" fmla="*/ 0 h 1776"/>
                          <a:gd name="T2" fmla="*/ 570 w 570"/>
                          <a:gd name="T3" fmla="*/ 0 h 1776"/>
                          <a:gd name="T4" fmla="*/ 570 w 570"/>
                          <a:gd name="T5" fmla="*/ 1776 h 1776"/>
                          <a:gd name="T6" fmla="*/ 0 w 570"/>
                          <a:gd name="T7" fmla="*/ 1776 h 1776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776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776"/>
                            </a:lnTo>
                            <a:lnTo>
                              <a:pt x="0" y="1776"/>
                            </a:lnTo>
                          </a:path>
                        </a:pathLst>
                      </a:custGeom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57" name="Line 187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2882900" y="2484438"/>
                        <a:ext cx="0" cy="93980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4" name="Freeform 194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3033713" y="2362200"/>
                        <a:ext cx="0" cy="122238"/>
                      </a:xfrm>
                      <a:custGeom>
                        <a:avLst/>
                        <a:gdLst>
                          <a:gd name="T0" fmla="*/ 191 h 191"/>
                          <a:gd name="T1" fmla="*/ 0 h 191"/>
                          <a:gd name="T2" fmla="*/ 0 h 191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191">
                            <a:moveTo>
                              <a:pt x="0" y="191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65" name="Line 195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006725" y="2362200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sp>
                  <p:nvSpPr>
                    <p:cNvPr id="167" name="Line 197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028825" y="33734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8" name="Line 198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430463" y="33734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69" name="Line 199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833688" y="3373438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3" name="Line 20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7188" y="309245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4" name="Line 20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7188" y="276225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5" name="Line 20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7188" y="2430463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6" name="Line 20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7188" y="3257550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7" name="Line 20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7188" y="2927350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8" name="Line 20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7188" y="2597150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79" name="Line 20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627188" y="2265363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</p:grpSp>
              <p:grpSp>
                <p:nvGrpSpPr>
                  <p:cNvPr id="498" name="Group 497"/>
                  <p:cNvGrpSpPr/>
                  <p:nvPr/>
                </p:nvGrpSpPr>
                <p:grpSpPr>
                  <a:xfrm>
                    <a:off x="1640310" y="3441196"/>
                    <a:ext cx="1577129" cy="367844"/>
                    <a:chOff x="1619464" y="1599671"/>
                    <a:chExt cx="1577129" cy="367844"/>
                  </a:xfrm>
                </p:grpSpPr>
                <p:sp>
                  <p:nvSpPr>
                    <p:cNvPr id="499" name="TextBox 498"/>
                    <p:cNvSpPr txBox="1"/>
                    <p:nvPr/>
                  </p:nvSpPr>
                  <p:spPr>
                    <a:xfrm>
                      <a:off x="1619464" y="1599671"/>
                      <a:ext cx="41549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0" name="TextBox 499"/>
                    <p:cNvSpPr txBox="1"/>
                    <p:nvPr/>
                  </p:nvSpPr>
                  <p:spPr>
                    <a:xfrm>
                      <a:off x="2064382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1" name="TextBox 500"/>
                    <p:cNvSpPr txBox="1"/>
                    <p:nvPr/>
                  </p:nvSpPr>
                  <p:spPr>
                    <a:xfrm>
                      <a:off x="2466321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2" name="TextBox 501"/>
                    <p:cNvSpPr txBox="1"/>
                    <p:nvPr/>
                  </p:nvSpPr>
                  <p:spPr>
                    <a:xfrm>
                      <a:off x="2867657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3" name="TextBox 502"/>
                    <p:cNvSpPr txBox="1"/>
                    <p:nvPr/>
                  </p:nvSpPr>
                  <p:spPr>
                    <a:xfrm>
                      <a:off x="2067238" y="1752071"/>
                      <a:ext cx="72327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AB30, µM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38" name="TextBox 537"/>
                  <p:cNvSpPr txBox="1"/>
                  <p:nvPr/>
                </p:nvSpPr>
                <p:spPr>
                  <a:xfrm>
                    <a:off x="1376318" y="2329503"/>
                    <a:ext cx="30008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4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39" name="TextBox 538"/>
                  <p:cNvSpPr txBox="1"/>
                  <p:nvPr/>
                </p:nvSpPr>
                <p:spPr>
                  <a:xfrm>
                    <a:off x="1376318" y="2654528"/>
                    <a:ext cx="300082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6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0" name="TextBox 539"/>
                  <p:cNvSpPr txBox="1"/>
                  <p:nvPr/>
                </p:nvSpPr>
                <p:spPr>
                  <a:xfrm>
                    <a:off x="1434026" y="2981553"/>
                    <a:ext cx="242374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67" name="TextBox 566"/>
                <p:cNvSpPr txBox="1"/>
                <p:nvPr/>
              </p:nvSpPr>
              <p:spPr>
                <a:xfrm rot="16200000">
                  <a:off x="927945" y="2652673"/>
                  <a:ext cx="82426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GABRP</a:t>
                  </a:r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PIA</a:t>
                  </a:r>
                  <a:endPara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47" name="Group 446"/>
              <p:cNvGrpSpPr/>
              <p:nvPr/>
            </p:nvGrpSpPr>
            <p:grpSpPr>
              <a:xfrm>
                <a:off x="1232356" y="4512575"/>
                <a:ext cx="2031017" cy="1735825"/>
                <a:chOff x="1232356" y="3941197"/>
                <a:chExt cx="2031017" cy="1735825"/>
              </a:xfrm>
            </p:grpSpPr>
            <p:grpSp>
              <p:nvGrpSpPr>
                <p:cNvPr id="439" name="Group 438"/>
                <p:cNvGrpSpPr/>
                <p:nvPr/>
              </p:nvGrpSpPr>
              <p:grpSpPr>
                <a:xfrm>
                  <a:off x="1378687" y="3941197"/>
                  <a:ext cx="1884686" cy="1735825"/>
                  <a:chOff x="1423664" y="3941197"/>
                  <a:chExt cx="1884686" cy="1735825"/>
                </a:xfrm>
              </p:grpSpPr>
              <p:grpSp>
                <p:nvGrpSpPr>
                  <p:cNvPr id="430" name="Group 429"/>
                  <p:cNvGrpSpPr/>
                  <p:nvPr/>
                </p:nvGrpSpPr>
                <p:grpSpPr>
                  <a:xfrm>
                    <a:off x="1697832" y="4046538"/>
                    <a:ext cx="1610518" cy="1243806"/>
                    <a:chOff x="1697832" y="4046538"/>
                    <a:chExt cx="1610518" cy="1243806"/>
                  </a:xfrm>
                </p:grpSpPr>
                <p:sp>
                  <p:nvSpPr>
                    <p:cNvPr id="265" name="Rectangle 264"/>
                    <p:cNvSpPr/>
                    <p:nvPr/>
                  </p:nvSpPr>
                  <p:spPr>
                    <a:xfrm>
                      <a:off x="1697832" y="4048919"/>
                      <a:ext cx="1608137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201" name="Rectangle 22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700213" y="4046538"/>
                      <a:ext cx="1608137" cy="1239838"/>
                    </a:xfrm>
                    <a:prstGeom prst="rect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2" name="Rectangle 229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749425" y="4247356"/>
                      <a:ext cx="301625" cy="1042988"/>
                    </a:xfrm>
                    <a:prstGeom prst="rect">
                      <a:avLst/>
                    </a:prstGeom>
                    <a:solidFill>
                      <a:schemeClr val="bg1">
                        <a:lumMod val="85000"/>
                      </a:schemeClr>
                    </a:solidFill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3" name="Freeform 230"/>
                    <p:cNvSpPr>
                      <a:spLocks/>
                    </p:cNvSpPr>
                    <p:nvPr/>
                  </p:nvSpPr>
                  <p:spPr bwMode="auto">
                    <a:xfrm>
                      <a:off x="1749425" y="4243388"/>
                      <a:ext cx="301625" cy="1042988"/>
                    </a:xfrm>
                    <a:custGeom>
                      <a:avLst/>
                      <a:gdLst>
                        <a:gd name="T0" fmla="*/ 0 w 570"/>
                        <a:gd name="T1" fmla="*/ 0 h 1973"/>
                        <a:gd name="T2" fmla="*/ 570 w 570"/>
                        <a:gd name="T3" fmla="*/ 0 h 1973"/>
                        <a:gd name="T4" fmla="*/ 570 w 570"/>
                        <a:gd name="T5" fmla="*/ 1973 h 1973"/>
                        <a:gd name="T6" fmla="*/ 0 w 570"/>
                        <a:gd name="T7" fmla="*/ 1973 h 1973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</a:cxnLst>
                      <a:rect l="0" t="0" r="r" b="b"/>
                      <a:pathLst>
                        <a:path w="570" h="1973">
                          <a:moveTo>
                            <a:pt x="0" y="0"/>
                          </a:moveTo>
                          <a:lnTo>
                            <a:pt x="570" y="0"/>
                          </a:lnTo>
                          <a:lnTo>
                            <a:pt x="570" y="1973"/>
                          </a:lnTo>
                          <a:lnTo>
                            <a:pt x="0" y="1973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4" name="Line 231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1749425" y="4243388"/>
                      <a:ext cx="0" cy="1042988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5" name="Rectangle 23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151063" y="4607719"/>
                      <a:ext cx="303212" cy="682625"/>
                    </a:xfrm>
                    <a:prstGeom prst="rect">
                      <a:avLst/>
                    </a:prstGeom>
                    <a:solidFill>
                      <a:schemeClr val="bg1">
                        <a:lumMod val="65000"/>
                      </a:schemeClr>
                    </a:solidFill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6" name="Freeform 233"/>
                    <p:cNvSpPr>
                      <a:spLocks/>
                    </p:cNvSpPr>
                    <p:nvPr/>
                  </p:nvSpPr>
                  <p:spPr bwMode="auto">
                    <a:xfrm>
                      <a:off x="2151063" y="4603750"/>
                      <a:ext cx="303212" cy="682625"/>
                    </a:xfrm>
                    <a:custGeom>
                      <a:avLst/>
                      <a:gdLst>
                        <a:gd name="T0" fmla="*/ 0 w 571"/>
                        <a:gd name="T1" fmla="*/ 0 h 1290"/>
                        <a:gd name="T2" fmla="*/ 571 w 571"/>
                        <a:gd name="T3" fmla="*/ 0 h 1290"/>
                        <a:gd name="T4" fmla="*/ 571 w 571"/>
                        <a:gd name="T5" fmla="*/ 1290 h 1290"/>
                        <a:gd name="T6" fmla="*/ 0 w 571"/>
                        <a:gd name="T7" fmla="*/ 1290 h 1290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</a:cxnLst>
                      <a:rect l="0" t="0" r="r" b="b"/>
                      <a:pathLst>
                        <a:path w="571" h="1290">
                          <a:moveTo>
                            <a:pt x="0" y="0"/>
                          </a:moveTo>
                          <a:lnTo>
                            <a:pt x="571" y="0"/>
                          </a:lnTo>
                          <a:lnTo>
                            <a:pt x="571" y="1290"/>
                          </a:lnTo>
                          <a:lnTo>
                            <a:pt x="0" y="1290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8" name="Line 234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151063" y="4603750"/>
                      <a:ext cx="0" cy="682625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09" name="Rectangle 235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554288" y="4442619"/>
                      <a:ext cx="301625" cy="847725"/>
                    </a:xfrm>
                    <a:prstGeom prst="rect">
                      <a:avLst/>
                    </a:prstGeom>
                    <a:solidFill>
                      <a:schemeClr val="tx1">
                        <a:lumMod val="50000"/>
                        <a:lumOff val="50000"/>
                      </a:schemeClr>
                    </a:solidFill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0" name="Freeform 236"/>
                    <p:cNvSpPr>
                      <a:spLocks/>
                    </p:cNvSpPr>
                    <p:nvPr/>
                  </p:nvSpPr>
                  <p:spPr bwMode="auto">
                    <a:xfrm>
                      <a:off x="2554288" y="4438650"/>
                      <a:ext cx="301625" cy="847725"/>
                    </a:xfrm>
                    <a:custGeom>
                      <a:avLst/>
                      <a:gdLst>
                        <a:gd name="T0" fmla="*/ 0 w 570"/>
                        <a:gd name="T1" fmla="*/ 0 h 1602"/>
                        <a:gd name="T2" fmla="*/ 570 w 570"/>
                        <a:gd name="T3" fmla="*/ 0 h 1602"/>
                        <a:gd name="T4" fmla="*/ 570 w 570"/>
                        <a:gd name="T5" fmla="*/ 1602 h 1602"/>
                        <a:gd name="T6" fmla="*/ 0 w 570"/>
                        <a:gd name="T7" fmla="*/ 1602 h 1602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</a:cxnLst>
                      <a:rect l="0" t="0" r="r" b="b"/>
                      <a:pathLst>
                        <a:path w="570" h="1602">
                          <a:moveTo>
                            <a:pt x="0" y="0"/>
                          </a:moveTo>
                          <a:lnTo>
                            <a:pt x="570" y="0"/>
                          </a:lnTo>
                          <a:lnTo>
                            <a:pt x="570" y="1602"/>
                          </a:lnTo>
                          <a:lnTo>
                            <a:pt x="0" y="1602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1" name="Line 237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554288" y="4438650"/>
                      <a:ext cx="0" cy="847725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2" name="Rectangle 23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2955925" y="4742656"/>
                      <a:ext cx="301625" cy="547688"/>
                    </a:xfrm>
                    <a:prstGeom prst="rect">
                      <a:avLst/>
                    </a:prstGeom>
                    <a:solidFill>
                      <a:schemeClr val="tx1">
                        <a:lumMod val="65000"/>
                        <a:lumOff val="35000"/>
                      </a:schemeClr>
                    </a:solidFill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3" name="Freeform 239"/>
                    <p:cNvSpPr>
                      <a:spLocks/>
                    </p:cNvSpPr>
                    <p:nvPr/>
                  </p:nvSpPr>
                  <p:spPr bwMode="auto">
                    <a:xfrm>
                      <a:off x="2955925" y="4738688"/>
                      <a:ext cx="301625" cy="547688"/>
                    </a:xfrm>
                    <a:custGeom>
                      <a:avLst/>
                      <a:gdLst>
                        <a:gd name="T0" fmla="*/ 0 w 571"/>
                        <a:gd name="T1" fmla="*/ 0 h 1035"/>
                        <a:gd name="T2" fmla="*/ 571 w 571"/>
                        <a:gd name="T3" fmla="*/ 0 h 1035"/>
                        <a:gd name="T4" fmla="*/ 571 w 571"/>
                        <a:gd name="T5" fmla="*/ 1035 h 1035"/>
                        <a:gd name="T6" fmla="*/ 0 w 571"/>
                        <a:gd name="T7" fmla="*/ 1035 h 1035"/>
                      </a:gdLst>
                      <a:ahLst/>
                      <a:cxnLst>
                        <a:cxn ang="0">
                          <a:pos x="T0" y="T1"/>
                        </a:cxn>
                        <a:cxn ang="0">
                          <a:pos x="T2" y="T3"/>
                        </a:cxn>
                        <a:cxn ang="0">
                          <a:pos x="T4" y="T5"/>
                        </a:cxn>
                        <a:cxn ang="0">
                          <a:pos x="T6" y="T7"/>
                        </a:cxn>
                      </a:cxnLst>
                      <a:rect l="0" t="0" r="r" b="b"/>
                      <a:pathLst>
                        <a:path w="571" h="1035">
                          <a:moveTo>
                            <a:pt x="0" y="0"/>
                          </a:moveTo>
                          <a:lnTo>
                            <a:pt x="571" y="0"/>
                          </a:lnTo>
                          <a:lnTo>
                            <a:pt x="571" y="1035"/>
                          </a:lnTo>
                          <a:lnTo>
                            <a:pt x="0" y="1035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4" name="Line 240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955925" y="4738688"/>
                      <a:ext cx="0" cy="547688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5" name="Freeform 241"/>
                    <p:cNvSpPr>
                      <a:spLocks/>
                    </p:cNvSpPr>
                    <p:nvPr/>
                  </p:nvSpPr>
                  <p:spPr bwMode="auto">
                    <a:xfrm flipV="1">
                      <a:off x="1901825" y="4098925"/>
                      <a:ext cx="0" cy="144463"/>
                    </a:xfrm>
                    <a:custGeom>
                      <a:avLst/>
                      <a:gdLst>
                        <a:gd name="T0" fmla="*/ 226 h 226"/>
                        <a:gd name="T1" fmla="*/ 0 h 226"/>
                        <a:gd name="T2" fmla="*/ 0 h 226"/>
                      </a:gdLst>
                      <a:ahLst/>
                      <a:cxnLst>
                        <a:cxn ang="0">
                          <a:pos x="0" y="T0"/>
                        </a:cxn>
                        <a:cxn ang="0">
                          <a:pos x="0" y="T1"/>
                        </a:cxn>
                        <a:cxn ang="0">
                          <a:pos x="0" y="T2"/>
                        </a:cxn>
                      </a:cxnLst>
                      <a:rect l="0" t="0" r="r" b="b"/>
                      <a:pathLst>
                        <a:path h="226">
                          <a:moveTo>
                            <a:pt x="0" y="226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6" name="Line 242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874838" y="4098925"/>
                      <a:ext cx="52387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7" name="Freeform 243"/>
                    <p:cNvSpPr>
                      <a:spLocks/>
                    </p:cNvSpPr>
                    <p:nvPr/>
                  </p:nvSpPr>
                  <p:spPr bwMode="auto">
                    <a:xfrm flipV="1">
                      <a:off x="2303463" y="4500563"/>
                      <a:ext cx="0" cy="103188"/>
                    </a:xfrm>
                    <a:custGeom>
                      <a:avLst/>
                      <a:gdLst>
                        <a:gd name="T0" fmla="*/ 162 h 162"/>
                        <a:gd name="T1" fmla="*/ 0 h 162"/>
                        <a:gd name="T2" fmla="*/ 0 h 162"/>
                      </a:gdLst>
                      <a:ahLst/>
                      <a:cxnLst>
                        <a:cxn ang="0">
                          <a:pos x="0" y="T0"/>
                        </a:cxn>
                        <a:cxn ang="0">
                          <a:pos x="0" y="T1"/>
                        </a:cxn>
                        <a:cxn ang="0">
                          <a:pos x="0" y="T2"/>
                        </a:cxn>
                      </a:cxnLst>
                      <a:rect l="0" t="0" r="r" b="b"/>
                      <a:pathLst>
                        <a:path h="162">
                          <a:moveTo>
                            <a:pt x="0" y="162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8" name="Line 244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276475" y="4500563"/>
                      <a:ext cx="53975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19" name="Freeform 245"/>
                    <p:cNvSpPr>
                      <a:spLocks/>
                    </p:cNvSpPr>
                    <p:nvPr/>
                  </p:nvSpPr>
                  <p:spPr bwMode="auto">
                    <a:xfrm flipV="1">
                      <a:off x="2705100" y="4232275"/>
                      <a:ext cx="0" cy="206375"/>
                    </a:xfrm>
                    <a:custGeom>
                      <a:avLst/>
                      <a:gdLst>
                        <a:gd name="T0" fmla="*/ 324 h 324"/>
                        <a:gd name="T1" fmla="*/ 0 h 324"/>
                        <a:gd name="T2" fmla="*/ 0 h 324"/>
                      </a:gdLst>
                      <a:ahLst/>
                      <a:cxnLst>
                        <a:cxn ang="0">
                          <a:pos x="0" y="T0"/>
                        </a:cxn>
                        <a:cxn ang="0">
                          <a:pos x="0" y="T1"/>
                        </a:cxn>
                        <a:cxn ang="0">
                          <a:pos x="0" y="T2"/>
                        </a:cxn>
                      </a:cxnLst>
                      <a:rect l="0" t="0" r="r" b="b"/>
                      <a:pathLst>
                        <a:path h="324">
                          <a:moveTo>
                            <a:pt x="0" y="324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20" name="Line 24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2678113" y="4232275"/>
                      <a:ext cx="53975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21" name="Freeform 247"/>
                    <p:cNvSpPr>
                      <a:spLocks/>
                    </p:cNvSpPr>
                    <p:nvPr/>
                  </p:nvSpPr>
                  <p:spPr bwMode="auto">
                    <a:xfrm flipV="1">
                      <a:off x="3106738" y="4594225"/>
                      <a:ext cx="0" cy="144463"/>
                    </a:xfrm>
                    <a:custGeom>
                      <a:avLst/>
                      <a:gdLst>
                        <a:gd name="T0" fmla="*/ 227 h 227"/>
                        <a:gd name="T1" fmla="*/ 0 h 227"/>
                        <a:gd name="T2" fmla="*/ 0 h 227"/>
                      </a:gdLst>
                      <a:ahLst/>
                      <a:cxnLst>
                        <a:cxn ang="0">
                          <a:pos x="0" y="T0"/>
                        </a:cxn>
                        <a:cxn ang="0">
                          <a:pos x="0" y="T1"/>
                        </a:cxn>
                        <a:cxn ang="0">
                          <a:pos x="0" y="T2"/>
                        </a:cxn>
                      </a:cxnLst>
                      <a:rect l="0" t="0" r="r" b="b"/>
                      <a:pathLst>
                        <a:path h="227">
                          <a:moveTo>
                            <a:pt x="0" y="227"/>
                          </a:moveTo>
                          <a:lnTo>
                            <a:pt x="0" y="0"/>
                          </a:lnTo>
                          <a:lnTo>
                            <a:pt x="0" y="0"/>
                          </a:lnTo>
                        </a:path>
                      </a:pathLst>
                    </a:cu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22" name="Line 24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079750" y="4594225"/>
                      <a:ext cx="53975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24" name="Line 250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101850" y="5241131"/>
                      <a:ext cx="0" cy="49213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25" name="Line 251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503488" y="5241131"/>
                      <a:ext cx="0" cy="49213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26" name="Line 252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905125" y="5241131"/>
                      <a:ext cx="0" cy="49213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30" name="Line 25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00213" y="4873625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31" name="Line 25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00213" y="4459288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33" name="Line 25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00213" y="5080000"/>
                      <a:ext cx="33337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34" name="Line 26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00213" y="4665663"/>
                      <a:ext cx="33337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35" name="Line 26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00213" y="4252913"/>
                      <a:ext cx="33337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</p:grpSp>
              <p:grpSp>
                <p:nvGrpSpPr>
                  <p:cNvPr id="504" name="Group 503"/>
                  <p:cNvGrpSpPr/>
                  <p:nvPr/>
                </p:nvGrpSpPr>
                <p:grpSpPr>
                  <a:xfrm>
                    <a:off x="1715716" y="5309178"/>
                    <a:ext cx="1577129" cy="367844"/>
                    <a:chOff x="1619464" y="1599671"/>
                    <a:chExt cx="1577129" cy="367844"/>
                  </a:xfrm>
                </p:grpSpPr>
                <p:sp>
                  <p:nvSpPr>
                    <p:cNvPr id="505" name="TextBox 504"/>
                    <p:cNvSpPr txBox="1"/>
                    <p:nvPr/>
                  </p:nvSpPr>
                  <p:spPr>
                    <a:xfrm>
                      <a:off x="1619464" y="1599671"/>
                      <a:ext cx="41549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6" name="TextBox 505"/>
                    <p:cNvSpPr txBox="1"/>
                    <p:nvPr/>
                  </p:nvSpPr>
                  <p:spPr>
                    <a:xfrm>
                      <a:off x="2064382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7" name="TextBox 506"/>
                    <p:cNvSpPr txBox="1"/>
                    <p:nvPr/>
                  </p:nvSpPr>
                  <p:spPr>
                    <a:xfrm>
                      <a:off x="2466321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8" name="TextBox 507"/>
                    <p:cNvSpPr txBox="1"/>
                    <p:nvPr/>
                  </p:nvSpPr>
                  <p:spPr>
                    <a:xfrm>
                      <a:off x="2867657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09" name="TextBox 508"/>
                    <p:cNvSpPr txBox="1"/>
                    <p:nvPr/>
                  </p:nvSpPr>
                  <p:spPr>
                    <a:xfrm>
                      <a:off x="2067238" y="1752071"/>
                      <a:ext cx="72327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AB30, µM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42" name="TextBox 541"/>
                  <p:cNvSpPr txBox="1"/>
                  <p:nvPr/>
                </p:nvSpPr>
                <p:spPr>
                  <a:xfrm>
                    <a:off x="1423664" y="3941197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2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3" name="TextBox 542"/>
                  <p:cNvSpPr txBox="1"/>
                  <p:nvPr/>
                </p:nvSpPr>
                <p:spPr>
                  <a:xfrm>
                    <a:off x="1423664" y="4352528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8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4" name="TextBox 543"/>
                  <p:cNvSpPr txBox="1"/>
                  <p:nvPr/>
                </p:nvSpPr>
                <p:spPr>
                  <a:xfrm>
                    <a:off x="1423664" y="4768850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4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68" name="TextBox 567"/>
                <p:cNvSpPr txBox="1"/>
                <p:nvPr/>
              </p:nvSpPr>
              <p:spPr>
                <a:xfrm rot="16200000">
                  <a:off x="1004088" y="4625970"/>
                  <a:ext cx="671979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Ki67</a:t>
                  </a:r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PIA</a:t>
                  </a:r>
                  <a:endPara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50" name="Group 449"/>
              <p:cNvGrpSpPr/>
              <p:nvPr/>
            </p:nvGrpSpPr>
            <p:grpSpPr>
              <a:xfrm>
                <a:off x="1232356" y="6255855"/>
                <a:ext cx="2031017" cy="1745145"/>
                <a:chOff x="1232356" y="5664428"/>
                <a:chExt cx="2031017" cy="1745145"/>
              </a:xfrm>
            </p:grpSpPr>
            <p:grpSp>
              <p:nvGrpSpPr>
                <p:cNvPr id="441" name="Group 440"/>
                <p:cNvGrpSpPr/>
                <p:nvPr/>
              </p:nvGrpSpPr>
              <p:grpSpPr>
                <a:xfrm>
                  <a:off x="1385037" y="5664428"/>
                  <a:ext cx="1878336" cy="1745145"/>
                  <a:chOff x="1499864" y="5664428"/>
                  <a:chExt cx="1878336" cy="1745145"/>
                </a:xfrm>
              </p:grpSpPr>
              <p:grpSp>
                <p:nvGrpSpPr>
                  <p:cNvPr id="432" name="Group 431"/>
                  <p:cNvGrpSpPr/>
                  <p:nvPr/>
                </p:nvGrpSpPr>
                <p:grpSpPr>
                  <a:xfrm>
                    <a:off x="1770063" y="5772150"/>
                    <a:ext cx="1608137" cy="1241426"/>
                    <a:chOff x="1770063" y="5772150"/>
                    <a:chExt cx="1608137" cy="1241426"/>
                  </a:xfrm>
                </p:grpSpPr>
                <p:sp>
                  <p:nvSpPr>
                    <p:cNvPr id="69" name="Rectangle 68"/>
                    <p:cNvSpPr/>
                    <p:nvPr/>
                  </p:nvSpPr>
                  <p:spPr>
                    <a:xfrm>
                      <a:off x="1770063" y="5772150"/>
                      <a:ext cx="1608137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137" name="Rectangle 388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1770063" y="5773738"/>
                      <a:ext cx="1606550" cy="1239838"/>
                    </a:xfrm>
                    <a:prstGeom prst="rect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40" name="Line 391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1770063" y="6238875"/>
                      <a:ext cx="0" cy="7747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421" name="Group 420"/>
                    <p:cNvGrpSpPr/>
                    <p:nvPr/>
                  </p:nvGrpSpPr>
                  <p:grpSpPr>
                    <a:xfrm>
                      <a:off x="1819275" y="6184900"/>
                      <a:ext cx="301625" cy="828675"/>
                      <a:chOff x="1819275" y="6184900"/>
                      <a:chExt cx="301625" cy="828675"/>
                    </a:xfrm>
                    <a:solidFill>
                      <a:srgbClr val="CC99FF"/>
                    </a:solidFill>
                  </p:grpSpPr>
                  <p:sp>
                    <p:nvSpPr>
                      <p:cNvPr id="1138" name="Rectangle 389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1819275" y="6238875"/>
                        <a:ext cx="301625" cy="77470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39" name="Freeform 390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1819275" y="6238875"/>
                        <a:ext cx="301625" cy="774700"/>
                      </a:xfrm>
                      <a:custGeom>
                        <a:avLst/>
                        <a:gdLst>
                          <a:gd name="T0" fmla="*/ 0 w 569"/>
                          <a:gd name="T1" fmla="*/ 0 h 1464"/>
                          <a:gd name="T2" fmla="*/ 569 w 569"/>
                          <a:gd name="T3" fmla="*/ 0 h 1464"/>
                          <a:gd name="T4" fmla="*/ 569 w 569"/>
                          <a:gd name="T5" fmla="*/ 1464 h 1464"/>
                          <a:gd name="T6" fmla="*/ 0 w 569"/>
                          <a:gd name="T7" fmla="*/ 1464 h 1464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69" h="1464">
                            <a:moveTo>
                              <a:pt x="0" y="0"/>
                            </a:moveTo>
                            <a:lnTo>
                              <a:pt x="569" y="0"/>
                            </a:lnTo>
                            <a:lnTo>
                              <a:pt x="569" y="1464"/>
                            </a:lnTo>
                            <a:lnTo>
                              <a:pt x="0" y="1464"/>
                            </a:lnTo>
                          </a:path>
                        </a:pathLst>
                      </a:custGeom>
                      <a:solidFill>
                        <a:schemeClr val="bg1">
                          <a:lumMod val="8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50" name="Freeform 401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1970088" y="6184900"/>
                        <a:ext cx="0" cy="53975"/>
                      </a:xfrm>
                      <a:custGeom>
                        <a:avLst/>
                        <a:gdLst>
                          <a:gd name="T0" fmla="*/ 86 h 86"/>
                          <a:gd name="T1" fmla="*/ 0 h 86"/>
                          <a:gd name="T2" fmla="*/ 0 h 86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86">
                            <a:moveTo>
                              <a:pt x="0" y="86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51" name="Line 402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1944688" y="6184900"/>
                        <a:ext cx="52388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422" name="Group 421"/>
                    <p:cNvGrpSpPr/>
                    <p:nvPr/>
                  </p:nvGrpSpPr>
                  <p:grpSpPr>
                    <a:xfrm>
                      <a:off x="2220913" y="6084888"/>
                      <a:ext cx="301625" cy="928687"/>
                      <a:chOff x="2220913" y="6084888"/>
                      <a:chExt cx="301625" cy="928687"/>
                    </a:xfrm>
                    <a:solidFill>
                      <a:srgbClr val="FFFF99"/>
                    </a:solidFill>
                  </p:grpSpPr>
                  <p:sp>
                    <p:nvSpPr>
                      <p:cNvPr id="1141" name="Rectangle 392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220913" y="6207125"/>
                        <a:ext cx="301625" cy="80645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42" name="Freeform 393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220913" y="6207125"/>
                        <a:ext cx="301625" cy="806450"/>
                      </a:xfrm>
                      <a:custGeom>
                        <a:avLst/>
                        <a:gdLst>
                          <a:gd name="T0" fmla="*/ 0 w 569"/>
                          <a:gd name="T1" fmla="*/ 0 h 1523"/>
                          <a:gd name="T2" fmla="*/ 569 w 569"/>
                          <a:gd name="T3" fmla="*/ 0 h 1523"/>
                          <a:gd name="T4" fmla="*/ 569 w 569"/>
                          <a:gd name="T5" fmla="*/ 1523 h 1523"/>
                          <a:gd name="T6" fmla="*/ 0 w 569"/>
                          <a:gd name="T7" fmla="*/ 1523 h 1523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69" h="1523">
                            <a:moveTo>
                              <a:pt x="0" y="0"/>
                            </a:moveTo>
                            <a:lnTo>
                              <a:pt x="569" y="0"/>
                            </a:lnTo>
                            <a:lnTo>
                              <a:pt x="569" y="1523"/>
                            </a:lnTo>
                            <a:lnTo>
                              <a:pt x="0" y="1523"/>
                            </a:lnTo>
                          </a:path>
                        </a:pathLst>
                      </a:custGeom>
                      <a:solidFill>
                        <a:schemeClr val="bg1">
                          <a:lumMod val="6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43" name="Line 394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2220913" y="6207125"/>
                        <a:ext cx="0" cy="80645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84" name="Freeform 403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2371725" y="6084888"/>
                        <a:ext cx="0" cy="122238"/>
                      </a:xfrm>
                      <a:custGeom>
                        <a:avLst/>
                        <a:gdLst>
                          <a:gd name="T0" fmla="*/ 194 h 194"/>
                          <a:gd name="T1" fmla="*/ 0 h 194"/>
                          <a:gd name="T2" fmla="*/ 0 h 194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194">
                            <a:moveTo>
                              <a:pt x="0" y="194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85" name="Line 40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344738" y="6084888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423" name="Group 422"/>
                    <p:cNvGrpSpPr/>
                    <p:nvPr/>
                  </p:nvGrpSpPr>
                  <p:grpSpPr>
                    <a:xfrm>
                      <a:off x="2622550" y="5967413"/>
                      <a:ext cx="301625" cy="1046162"/>
                      <a:chOff x="2622550" y="5967413"/>
                      <a:chExt cx="301625" cy="1046162"/>
                    </a:xfrm>
                    <a:solidFill>
                      <a:srgbClr val="FFFF66"/>
                    </a:solidFill>
                  </p:grpSpPr>
                  <p:sp>
                    <p:nvSpPr>
                      <p:cNvPr id="1144" name="Rectangle 395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2622550" y="6169025"/>
                        <a:ext cx="301625" cy="84455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45" name="Freeform 396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2622550" y="6169025"/>
                        <a:ext cx="301625" cy="844550"/>
                      </a:xfrm>
                      <a:custGeom>
                        <a:avLst/>
                        <a:gdLst>
                          <a:gd name="T0" fmla="*/ 0 w 570"/>
                          <a:gd name="T1" fmla="*/ 0 h 1596"/>
                          <a:gd name="T2" fmla="*/ 570 w 570"/>
                          <a:gd name="T3" fmla="*/ 0 h 1596"/>
                          <a:gd name="T4" fmla="*/ 570 w 570"/>
                          <a:gd name="T5" fmla="*/ 1596 h 1596"/>
                          <a:gd name="T6" fmla="*/ 0 w 570"/>
                          <a:gd name="T7" fmla="*/ 1596 h 1596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596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596"/>
                            </a:lnTo>
                            <a:lnTo>
                              <a:pt x="0" y="1596"/>
                            </a:lnTo>
                          </a:path>
                        </a:pathLst>
                      </a:cu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46" name="Line 397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2622550" y="6169025"/>
                        <a:ext cx="0" cy="84455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86" name="Freeform 405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2773363" y="5967413"/>
                        <a:ext cx="0" cy="201613"/>
                      </a:xfrm>
                      <a:custGeom>
                        <a:avLst/>
                        <a:gdLst>
                          <a:gd name="T0" fmla="*/ 316 h 316"/>
                          <a:gd name="T1" fmla="*/ 0 h 316"/>
                          <a:gd name="T2" fmla="*/ 0 h 316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316">
                            <a:moveTo>
                              <a:pt x="0" y="316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87" name="Line 40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2746375" y="5967413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424" name="Group 423"/>
                    <p:cNvGrpSpPr/>
                    <p:nvPr/>
                  </p:nvGrpSpPr>
                  <p:grpSpPr>
                    <a:xfrm>
                      <a:off x="3024188" y="5959475"/>
                      <a:ext cx="301625" cy="1054100"/>
                      <a:chOff x="3024188" y="5959475"/>
                      <a:chExt cx="301625" cy="1054100"/>
                    </a:xfrm>
                    <a:solidFill>
                      <a:srgbClr val="FFFF00"/>
                    </a:solidFill>
                  </p:grpSpPr>
                  <p:sp>
                    <p:nvSpPr>
                      <p:cNvPr id="1147" name="Rectangle 398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024188" y="6029325"/>
                        <a:ext cx="301625" cy="98425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48" name="Freeform 399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024188" y="6029325"/>
                        <a:ext cx="301625" cy="984250"/>
                      </a:xfrm>
                      <a:custGeom>
                        <a:avLst/>
                        <a:gdLst>
                          <a:gd name="T0" fmla="*/ 0 w 570"/>
                          <a:gd name="T1" fmla="*/ 0 h 1860"/>
                          <a:gd name="T2" fmla="*/ 570 w 570"/>
                          <a:gd name="T3" fmla="*/ 0 h 1860"/>
                          <a:gd name="T4" fmla="*/ 570 w 570"/>
                          <a:gd name="T5" fmla="*/ 1860 h 1860"/>
                          <a:gd name="T6" fmla="*/ 0 w 570"/>
                          <a:gd name="T7" fmla="*/ 1860 h 1860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860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860"/>
                            </a:lnTo>
                            <a:lnTo>
                              <a:pt x="0" y="1860"/>
                            </a:lnTo>
                          </a:path>
                        </a:pathLst>
                      </a:custGeom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149" name="Line 400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3024188" y="6029325"/>
                        <a:ext cx="0" cy="98425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88" name="Freeform 407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3175000" y="5959475"/>
                        <a:ext cx="0" cy="69850"/>
                      </a:xfrm>
                      <a:custGeom>
                        <a:avLst/>
                        <a:gdLst>
                          <a:gd name="T0" fmla="*/ 109 h 109"/>
                          <a:gd name="T1" fmla="*/ 0 h 109"/>
                          <a:gd name="T2" fmla="*/ 0 h 109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109">
                            <a:moveTo>
                              <a:pt x="0" y="109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89" name="Line 40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3148013" y="5959475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sp>
                  <p:nvSpPr>
                    <p:cNvPr id="391" name="Line 410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171700" y="6962775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92" name="Line 411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573338" y="6962775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93" name="Line 412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2974975" y="6962775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97" name="Line 41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70063" y="6704013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98" name="Line 41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70063" y="639445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399" name="Line 41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70063" y="608330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401" name="Line 42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70063" y="6859588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402" name="Line 42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70063" y="6548438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403" name="Line 422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70063" y="6238875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404" name="Line 42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1770063" y="5929313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</p:grpSp>
              <p:grpSp>
                <p:nvGrpSpPr>
                  <p:cNvPr id="510" name="Group 509"/>
                  <p:cNvGrpSpPr/>
                  <p:nvPr/>
                </p:nvGrpSpPr>
                <p:grpSpPr>
                  <a:xfrm>
                    <a:off x="1765723" y="7041729"/>
                    <a:ext cx="1577129" cy="367844"/>
                    <a:chOff x="1619464" y="1599671"/>
                    <a:chExt cx="1577129" cy="367844"/>
                  </a:xfrm>
                </p:grpSpPr>
                <p:sp>
                  <p:nvSpPr>
                    <p:cNvPr id="511" name="TextBox 510"/>
                    <p:cNvSpPr txBox="1"/>
                    <p:nvPr/>
                  </p:nvSpPr>
                  <p:spPr>
                    <a:xfrm>
                      <a:off x="1619464" y="1599671"/>
                      <a:ext cx="41549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2" name="TextBox 511"/>
                    <p:cNvSpPr txBox="1"/>
                    <p:nvPr/>
                  </p:nvSpPr>
                  <p:spPr>
                    <a:xfrm>
                      <a:off x="2064382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3" name="TextBox 512"/>
                    <p:cNvSpPr txBox="1"/>
                    <p:nvPr/>
                  </p:nvSpPr>
                  <p:spPr>
                    <a:xfrm>
                      <a:off x="2466321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4" name="TextBox 513"/>
                    <p:cNvSpPr txBox="1"/>
                    <p:nvPr/>
                  </p:nvSpPr>
                  <p:spPr>
                    <a:xfrm>
                      <a:off x="2867657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5" name="TextBox 514"/>
                    <p:cNvSpPr txBox="1"/>
                    <p:nvPr/>
                  </p:nvSpPr>
                  <p:spPr>
                    <a:xfrm>
                      <a:off x="2067238" y="1752071"/>
                      <a:ext cx="72327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AB30, µM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50" name="TextBox 549"/>
                  <p:cNvSpPr txBox="1"/>
                  <p:nvPr/>
                </p:nvSpPr>
                <p:spPr>
                  <a:xfrm>
                    <a:off x="1499864" y="5664428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6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1" name="TextBox 550"/>
                  <p:cNvSpPr txBox="1"/>
                  <p:nvPr/>
                </p:nvSpPr>
                <p:spPr>
                  <a:xfrm>
                    <a:off x="1499864" y="5975351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2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52" name="TextBox 551"/>
                  <p:cNvSpPr txBox="1"/>
                  <p:nvPr/>
                </p:nvSpPr>
                <p:spPr>
                  <a:xfrm>
                    <a:off x="1499864" y="6285140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8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62" name="TextBox 561"/>
                  <p:cNvSpPr txBox="1"/>
                  <p:nvPr/>
                </p:nvSpPr>
                <p:spPr>
                  <a:xfrm>
                    <a:off x="1499864" y="6591300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4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69" name="TextBox 568"/>
                <p:cNvSpPr txBox="1"/>
                <p:nvPr/>
              </p:nvSpPr>
              <p:spPr>
                <a:xfrm rot="16200000">
                  <a:off x="878252" y="6267996"/>
                  <a:ext cx="923651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REBP1c</a:t>
                  </a:r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PIA</a:t>
                  </a:r>
                  <a:endPara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48" name="Group 447"/>
              <p:cNvGrpSpPr/>
              <p:nvPr/>
            </p:nvGrpSpPr>
            <p:grpSpPr>
              <a:xfrm>
                <a:off x="3638550" y="4616329"/>
                <a:ext cx="2000250" cy="1632071"/>
                <a:chOff x="3505200" y="4044951"/>
                <a:chExt cx="2000250" cy="1632071"/>
              </a:xfrm>
            </p:grpSpPr>
            <p:grpSp>
              <p:nvGrpSpPr>
                <p:cNvPr id="440" name="Group 439"/>
                <p:cNvGrpSpPr/>
                <p:nvPr/>
              </p:nvGrpSpPr>
              <p:grpSpPr>
                <a:xfrm>
                  <a:off x="3616000" y="4044951"/>
                  <a:ext cx="1889450" cy="1632071"/>
                  <a:chOff x="3557264" y="4044951"/>
                  <a:chExt cx="1889450" cy="1632071"/>
                </a:xfrm>
              </p:grpSpPr>
              <p:grpSp>
                <p:nvGrpSpPr>
                  <p:cNvPr id="431" name="Group 430"/>
                  <p:cNvGrpSpPr/>
                  <p:nvPr/>
                </p:nvGrpSpPr>
                <p:grpSpPr>
                  <a:xfrm>
                    <a:off x="3837781" y="4044951"/>
                    <a:ext cx="1608933" cy="1241425"/>
                    <a:chOff x="3837781" y="4044951"/>
                    <a:chExt cx="1608933" cy="1241425"/>
                  </a:xfrm>
                </p:grpSpPr>
                <p:sp>
                  <p:nvSpPr>
                    <p:cNvPr id="264" name="Rectangle 263"/>
                    <p:cNvSpPr/>
                    <p:nvPr/>
                  </p:nvSpPr>
                  <p:spPr>
                    <a:xfrm>
                      <a:off x="3837781" y="4044951"/>
                      <a:ext cx="1608137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253" name="Rectangle 28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38576" y="4046538"/>
                      <a:ext cx="1608138" cy="1239838"/>
                    </a:xfrm>
                    <a:prstGeom prst="rect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308" name="Group 307"/>
                    <p:cNvGrpSpPr/>
                    <p:nvPr/>
                  </p:nvGrpSpPr>
                  <p:grpSpPr>
                    <a:xfrm>
                      <a:off x="3887788" y="4348164"/>
                      <a:ext cx="303213" cy="938212"/>
                      <a:chOff x="3887788" y="4348163"/>
                      <a:chExt cx="303213" cy="938212"/>
                    </a:xfrm>
                    <a:solidFill>
                      <a:srgbClr val="CC99FF"/>
                    </a:solidFill>
                  </p:grpSpPr>
                  <p:sp>
                    <p:nvSpPr>
                      <p:cNvPr id="254" name="Rectangle 281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887788" y="4400550"/>
                        <a:ext cx="303213" cy="885825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5" name="Freeform 282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887788" y="4400550"/>
                        <a:ext cx="303213" cy="885825"/>
                      </a:xfrm>
                      <a:custGeom>
                        <a:avLst/>
                        <a:gdLst>
                          <a:gd name="T0" fmla="*/ 0 w 571"/>
                          <a:gd name="T1" fmla="*/ 0 h 1673"/>
                          <a:gd name="T2" fmla="*/ 571 w 571"/>
                          <a:gd name="T3" fmla="*/ 0 h 1673"/>
                          <a:gd name="T4" fmla="*/ 571 w 571"/>
                          <a:gd name="T5" fmla="*/ 1673 h 1673"/>
                          <a:gd name="T6" fmla="*/ 0 w 571"/>
                          <a:gd name="T7" fmla="*/ 1673 h 1673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1" h="1673">
                            <a:moveTo>
                              <a:pt x="0" y="0"/>
                            </a:moveTo>
                            <a:lnTo>
                              <a:pt x="571" y="0"/>
                            </a:lnTo>
                            <a:lnTo>
                              <a:pt x="571" y="1673"/>
                            </a:lnTo>
                            <a:lnTo>
                              <a:pt x="0" y="1673"/>
                            </a:lnTo>
                          </a:path>
                        </a:pathLst>
                      </a:custGeom>
                      <a:solidFill>
                        <a:schemeClr val="bg1">
                          <a:lumMod val="8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6" name="Line 283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3887788" y="4400550"/>
                        <a:ext cx="0" cy="885825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68" name="Freeform 293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040188" y="4348163"/>
                        <a:ext cx="0" cy="52388"/>
                      </a:xfrm>
                      <a:custGeom>
                        <a:avLst/>
                        <a:gdLst>
                          <a:gd name="T0" fmla="*/ 83 h 83"/>
                          <a:gd name="T1" fmla="*/ 0 h 83"/>
                          <a:gd name="T2" fmla="*/ 0 h 83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83">
                            <a:moveTo>
                              <a:pt x="0" y="83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69" name="Line 294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13201" y="4348163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307" name="Group 306"/>
                    <p:cNvGrpSpPr/>
                    <p:nvPr/>
                  </p:nvGrpSpPr>
                  <p:grpSpPr>
                    <a:xfrm>
                      <a:off x="4291013" y="4338638"/>
                      <a:ext cx="301625" cy="947738"/>
                      <a:chOff x="4291013" y="4338638"/>
                      <a:chExt cx="301625" cy="947738"/>
                    </a:xfrm>
                    <a:solidFill>
                      <a:srgbClr val="FFFF99"/>
                    </a:solidFill>
                  </p:grpSpPr>
                  <p:sp>
                    <p:nvSpPr>
                      <p:cNvPr id="257" name="Rectangle 28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291013" y="4427538"/>
                        <a:ext cx="301625" cy="858838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8" name="Freeform 285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4291013" y="4427538"/>
                        <a:ext cx="301625" cy="858838"/>
                      </a:xfrm>
                      <a:custGeom>
                        <a:avLst/>
                        <a:gdLst>
                          <a:gd name="T0" fmla="*/ 0 w 570"/>
                          <a:gd name="T1" fmla="*/ 0 h 1623"/>
                          <a:gd name="T2" fmla="*/ 570 w 570"/>
                          <a:gd name="T3" fmla="*/ 0 h 1623"/>
                          <a:gd name="T4" fmla="*/ 570 w 570"/>
                          <a:gd name="T5" fmla="*/ 1623 h 1623"/>
                          <a:gd name="T6" fmla="*/ 0 w 570"/>
                          <a:gd name="T7" fmla="*/ 1623 h 1623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623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623"/>
                            </a:lnTo>
                            <a:lnTo>
                              <a:pt x="0" y="1623"/>
                            </a:lnTo>
                          </a:path>
                        </a:pathLst>
                      </a:custGeom>
                      <a:solidFill>
                        <a:schemeClr val="bg1">
                          <a:lumMod val="6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59" name="Line 286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4291013" y="4427538"/>
                        <a:ext cx="0" cy="858838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70" name="Freeform 295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441826" y="4338638"/>
                        <a:ext cx="0" cy="88900"/>
                      </a:xfrm>
                      <a:custGeom>
                        <a:avLst/>
                        <a:gdLst>
                          <a:gd name="T0" fmla="*/ 139 h 139"/>
                          <a:gd name="T1" fmla="*/ 0 h 139"/>
                          <a:gd name="T2" fmla="*/ 0 h 139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139">
                            <a:moveTo>
                              <a:pt x="0" y="139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71" name="Line 296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14838" y="4338638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306" name="Group 305"/>
                    <p:cNvGrpSpPr/>
                    <p:nvPr/>
                  </p:nvGrpSpPr>
                  <p:grpSpPr>
                    <a:xfrm>
                      <a:off x="4692651" y="4311651"/>
                      <a:ext cx="301625" cy="974725"/>
                      <a:chOff x="4692651" y="4311650"/>
                      <a:chExt cx="301625" cy="974725"/>
                    </a:xfrm>
                    <a:solidFill>
                      <a:srgbClr val="FFFF66"/>
                    </a:solidFill>
                  </p:grpSpPr>
                  <p:sp>
                    <p:nvSpPr>
                      <p:cNvPr id="260" name="Rectangle 28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692651" y="4479925"/>
                        <a:ext cx="301625" cy="80645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61" name="Freeform 288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4692651" y="4479925"/>
                        <a:ext cx="301625" cy="806450"/>
                      </a:xfrm>
                      <a:custGeom>
                        <a:avLst/>
                        <a:gdLst>
                          <a:gd name="T0" fmla="*/ 0 w 570"/>
                          <a:gd name="T1" fmla="*/ 0 h 1523"/>
                          <a:gd name="T2" fmla="*/ 570 w 570"/>
                          <a:gd name="T3" fmla="*/ 0 h 1523"/>
                          <a:gd name="T4" fmla="*/ 570 w 570"/>
                          <a:gd name="T5" fmla="*/ 1523 h 1523"/>
                          <a:gd name="T6" fmla="*/ 0 w 570"/>
                          <a:gd name="T7" fmla="*/ 1523 h 1523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523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523"/>
                            </a:lnTo>
                            <a:lnTo>
                              <a:pt x="0" y="1523"/>
                            </a:lnTo>
                          </a:path>
                        </a:pathLst>
                      </a:cu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62" name="Line 289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4692651" y="4479925"/>
                        <a:ext cx="0" cy="80645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72" name="Freeform 297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843463" y="4311650"/>
                        <a:ext cx="0" cy="168275"/>
                      </a:xfrm>
                      <a:custGeom>
                        <a:avLst/>
                        <a:gdLst>
                          <a:gd name="T0" fmla="*/ 264 h 264"/>
                          <a:gd name="T1" fmla="*/ 0 h 264"/>
                          <a:gd name="T2" fmla="*/ 0 h 264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264">
                            <a:moveTo>
                              <a:pt x="0" y="264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73" name="Line 298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816476" y="4311650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305" name="Group 304"/>
                    <p:cNvGrpSpPr/>
                    <p:nvPr/>
                  </p:nvGrpSpPr>
                  <p:grpSpPr>
                    <a:xfrm>
                      <a:off x="5094288" y="4568826"/>
                      <a:ext cx="301625" cy="717550"/>
                      <a:chOff x="5094288" y="4568825"/>
                      <a:chExt cx="301625" cy="717550"/>
                    </a:xfrm>
                    <a:solidFill>
                      <a:srgbClr val="FFFF00"/>
                    </a:solidFill>
                  </p:grpSpPr>
                  <p:sp>
                    <p:nvSpPr>
                      <p:cNvPr id="263" name="Rectangle 29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5094288" y="4667250"/>
                        <a:ext cx="301625" cy="619125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66" name="Freeform 291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5094288" y="4667250"/>
                        <a:ext cx="301625" cy="619125"/>
                      </a:xfrm>
                      <a:custGeom>
                        <a:avLst/>
                        <a:gdLst>
                          <a:gd name="T0" fmla="*/ 0 w 570"/>
                          <a:gd name="T1" fmla="*/ 0 h 1171"/>
                          <a:gd name="T2" fmla="*/ 570 w 570"/>
                          <a:gd name="T3" fmla="*/ 0 h 1171"/>
                          <a:gd name="T4" fmla="*/ 570 w 570"/>
                          <a:gd name="T5" fmla="*/ 1171 h 1171"/>
                          <a:gd name="T6" fmla="*/ 0 w 570"/>
                          <a:gd name="T7" fmla="*/ 1171 h 1171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171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171"/>
                            </a:lnTo>
                            <a:lnTo>
                              <a:pt x="0" y="1171"/>
                            </a:lnTo>
                          </a:path>
                        </a:pathLst>
                      </a:custGeom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67" name="Line 292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5094288" y="4667250"/>
                        <a:ext cx="0" cy="619125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74" name="Freeform 299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5245101" y="4568825"/>
                        <a:ext cx="0" cy="98425"/>
                      </a:xfrm>
                      <a:custGeom>
                        <a:avLst/>
                        <a:gdLst>
                          <a:gd name="T0" fmla="*/ 153 h 153"/>
                          <a:gd name="T1" fmla="*/ 0 h 153"/>
                          <a:gd name="T2" fmla="*/ 0 h 153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153">
                            <a:moveTo>
                              <a:pt x="0" y="153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275" name="Line 300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218113" y="4568825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sp>
                  <p:nvSpPr>
                    <p:cNvPr id="277" name="Line 302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240213" y="5235576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8" name="Line 303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641851" y="5235576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79" name="Line 304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5045076" y="5235576"/>
                      <a:ext cx="0" cy="5080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3" name="Line 30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4932363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4" name="Line 309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457835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5" name="Line 310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4224338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6" name="Line 31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5108575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7" name="Line 312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4754563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288" name="Line 31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38576" y="4400550"/>
                      <a:ext cx="33338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</p:grpSp>
              <p:grpSp>
                <p:nvGrpSpPr>
                  <p:cNvPr id="528" name="Group 527"/>
                  <p:cNvGrpSpPr/>
                  <p:nvPr/>
                </p:nvGrpSpPr>
                <p:grpSpPr>
                  <a:xfrm>
                    <a:off x="3853286" y="5309178"/>
                    <a:ext cx="1577129" cy="367844"/>
                    <a:chOff x="1619464" y="1599671"/>
                    <a:chExt cx="1577129" cy="367844"/>
                  </a:xfrm>
                </p:grpSpPr>
                <p:sp>
                  <p:nvSpPr>
                    <p:cNvPr id="529" name="TextBox 528"/>
                    <p:cNvSpPr txBox="1"/>
                    <p:nvPr/>
                  </p:nvSpPr>
                  <p:spPr>
                    <a:xfrm>
                      <a:off x="1619464" y="1599671"/>
                      <a:ext cx="41549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0" name="TextBox 529"/>
                    <p:cNvSpPr txBox="1"/>
                    <p:nvPr/>
                  </p:nvSpPr>
                  <p:spPr>
                    <a:xfrm>
                      <a:off x="2064382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1" name="TextBox 530"/>
                    <p:cNvSpPr txBox="1"/>
                    <p:nvPr/>
                  </p:nvSpPr>
                  <p:spPr>
                    <a:xfrm>
                      <a:off x="2466321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2" name="TextBox 531"/>
                    <p:cNvSpPr txBox="1"/>
                    <p:nvPr/>
                  </p:nvSpPr>
                  <p:spPr>
                    <a:xfrm>
                      <a:off x="2867657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33" name="TextBox 532"/>
                    <p:cNvSpPr txBox="1"/>
                    <p:nvPr/>
                  </p:nvSpPr>
                  <p:spPr>
                    <a:xfrm>
                      <a:off x="2067238" y="1752071"/>
                      <a:ext cx="72327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AB30, µM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46" name="TextBox 545"/>
                  <p:cNvSpPr txBox="1"/>
                  <p:nvPr/>
                </p:nvSpPr>
                <p:spPr>
                  <a:xfrm>
                    <a:off x="3557264" y="4118997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2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7" name="TextBox 546"/>
                  <p:cNvSpPr txBox="1"/>
                  <p:nvPr/>
                </p:nvSpPr>
                <p:spPr>
                  <a:xfrm>
                    <a:off x="3557264" y="4473010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8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48" name="TextBox 547"/>
                  <p:cNvSpPr txBox="1"/>
                  <p:nvPr/>
                </p:nvSpPr>
                <p:spPr>
                  <a:xfrm>
                    <a:off x="3557264" y="4824641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4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70" name="TextBox 569"/>
                <p:cNvSpPr txBox="1"/>
                <p:nvPr/>
              </p:nvSpPr>
              <p:spPr>
                <a:xfrm rot="16200000">
                  <a:off x="3192774" y="4625970"/>
                  <a:ext cx="840295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HMGCR</a:t>
                  </a:r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PIA</a:t>
                  </a:r>
                  <a:endPara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449" name="Group 448"/>
              <p:cNvGrpSpPr/>
              <p:nvPr/>
            </p:nvGrpSpPr>
            <p:grpSpPr>
              <a:xfrm>
                <a:off x="3638550" y="6363578"/>
                <a:ext cx="2000250" cy="1637422"/>
                <a:chOff x="3505200" y="5772151"/>
                <a:chExt cx="2000250" cy="1637422"/>
              </a:xfrm>
            </p:grpSpPr>
            <p:grpSp>
              <p:nvGrpSpPr>
                <p:cNvPr id="442" name="Group 441"/>
                <p:cNvGrpSpPr/>
                <p:nvPr/>
              </p:nvGrpSpPr>
              <p:grpSpPr>
                <a:xfrm>
                  <a:off x="3633464" y="5772151"/>
                  <a:ext cx="1871986" cy="1637422"/>
                  <a:chOff x="3633464" y="5772151"/>
                  <a:chExt cx="1871986" cy="1637422"/>
                </a:xfrm>
              </p:grpSpPr>
              <p:grpSp>
                <p:nvGrpSpPr>
                  <p:cNvPr id="433" name="Group 432"/>
                  <p:cNvGrpSpPr/>
                  <p:nvPr/>
                </p:nvGrpSpPr>
                <p:grpSpPr>
                  <a:xfrm>
                    <a:off x="3895407" y="5772151"/>
                    <a:ext cx="1610043" cy="1241425"/>
                    <a:chOff x="3895407" y="5772151"/>
                    <a:chExt cx="1610043" cy="1241425"/>
                  </a:xfrm>
                </p:grpSpPr>
                <p:sp>
                  <p:nvSpPr>
                    <p:cNvPr id="311" name="Rectangle 33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97313" y="5773738"/>
                      <a:ext cx="1608137" cy="1239838"/>
                    </a:xfrm>
                    <a:prstGeom prst="rect">
                      <a:avLst/>
                    </a:prstGeom>
                    <a:noFill/>
                    <a:ln w="9525">
                      <a:solidFill>
                        <a:srgbClr val="000000"/>
                      </a:solidFill>
                      <a:miter lim="800000"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grpSp>
                  <p:nvGrpSpPr>
                    <p:cNvPr id="1131" name="Group 1130"/>
                    <p:cNvGrpSpPr/>
                    <p:nvPr/>
                  </p:nvGrpSpPr>
                  <p:grpSpPr>
                    <a:xfrm>
                      <a:off x="3946525" y="6200776"/>
                      <a:ext cx="301625" cy="812800"/>
                      <a:chOff x="3946525" y="6200775"/>
                      <a:chExt cx="301625" cy="812800"/>
                    </a:xfrm>
                    <a:solidFill>
                      <a:srgbClr val="CC99FF"/>
                    </a:solidFill>
                  </p:grpSpPr>
                  <p:sp>
                    <p:nvSpPr>
                      <p:cNvPr id="312" name="Rectangle 334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3946525" y="6238875"/>
                        <a:ext cx="301625" cy="77470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13" name="Freeform 335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3946525" y="6238875"/>
                        <a:ext cx="301625" cy="774700"/>
                      </a:xfrm>
                      <a:custGeom>
                        <a:avLst/>
                        <a:gdLst>
                          <a:gd name="T0" fmla="*/ 0 w 570"/>
                          <a:gd name="T1" fmla="*/ 0 h 1464"/>
                          <a:gd name="T2" fmla="*/ 570 w 570"/>
                          <a:gd name="T3" fmla="*/ 0 h 1464"/>
                          <a:gd name="T4" fmla="*/ 570 w 570"/>
                          <a:gd name="T5" fmla="*/ 1464 h 1464"/>
                          <a:gd name="T6" fmla="*/ 0 w 570"/>
                          <a:gd name="T7" fmla="*/ 1464 h 1464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464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464"/>
                            </a:lnTo>
                            <a:lnTo>
                              <a:pt x="0" y="1464"/>
                            </a:lnTo>
                          </a:path>
                        </a:pathLst>
                      </a:custGeom>
                      <a:solidFill>
                        <a:schemeClr val="bg1">
                          <a:lumMod val="8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14" name="Line 336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3946525" y="6238875"/>
                        <a:ext cx="0" cy="77470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2" name="Freeform 346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098925" y="6200775"/>
                        <a:ext cx="0" cy="38100"/>
                      </a:xfrm>
                      <a:custGeom>
                        <a:avLst/>
                        <a:gdLst>
                          <a:gd name="T0" fmla="*/ 61 h 61"/>
                          <a:gd name="T1" fmla="*/ 0 h 61"/>
                          <a:gd name="T2" fmla="*/ 0 h 61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61">
                            <a:moveTo>
                              <a:pt x="0" y="61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3" name="Line 347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071938" y="6200775"/>
                        <a:ext cx="52387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132" name="Group 1131"/>
                    <p:cNvGrpSpPr/>
                    <p:nvPr/>
                  </p:nvGrpSpPr>
                  <p:grpSpPr>
                    <a:xfrm>
                      <a:off x="4348163" y="6021389"/>
                      <a:ext cx="303212" cy="992187"/>
                      <a:chOff x="4348163" y="6021388"/>
                      <a:chExt cx="303212" cy="992187"/>
                    </a:xfrm>
                    <a:solidFill>
                      <a:srgbClr val="FFFF99"/>
                    </a:solidFill>
                  </p:grpSpPr>
                  <p:sp>
                    <p:nvSpPr>
                      <p:cNvPr id="315" name="Rectangle 337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348163" y="6238875"/>
                        <a:ext cx="303212" cy="77470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16" name="Freeform 338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4348163" y="6238875"/>
                        <a:ext cx="303212" cy="774700"/>
                      </a:xfrm>
                      <a:custGeom>
                        <a:avLst/>
                        <a:gdLst>
                          <a:gd name="T0" fmla="*/ 0 w 571"/>
                          <a:gd name="T1" fmla="*/ 0 h 1464"/>
                          <a:gd name="T2" fmla="*/ 571 w 571"/>
                          <a:gd name="T3" fmla="*/ 0 h 1464"/>
                          <a:gd name="T4" fmla="*/ 571 w 571"/>
                          <a:gd name="T5" fmla="*/ 1464 h 1464"/>
                          <a:gd name="T6" fmla="*/ 0 w 571"/>
                          <a:gd name="T7" fmla="*/ 1464 h 1464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1" h="1464">
                            <a:moveTo>
                              <a:pt x="0" y="0"/>
                            </a:moveTo>
                            <a:lnTo>
                              <a:pt x="571" y="0"/>
                            </a:lnTo>
                            <a:lnTo>
                              <a:pt x="571" y="1464"/>
                            </a:lnTo>
                            <a:lnTo>
                              <a:pt x="0" y="1464"/>
                            </a:lnTo>
                          </a:path>
                        </a:pathLst>
                      </a:custGeom>
                      <a:solidFill>
                        <a:schemeClr val="bg1">
                          <a:lumMod val="6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17" name="Line 339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4348163" y="6238875"/>
                        <a:ext cx="0" cy="77470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4" name="Freeform 348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500563" y="6021388"/>
                        <a:ext cx="0" cy="217488"/>
                      </a:xfrm>
                      <a:custGeom>
                        <a:avLst/>
                        <a:gdLst>
                          <a:gd name="T0" fmla="*/ 341 h 341"/>
                          <a:gd name="T1" fmla="*/ 0 h 341"/>
                          <a:gd name="T2" fmla="*/ 0 h 341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341">
                            <a:moveTo>
                              <a:pt x="0" y="341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5" name="Line 349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473575" y="6021388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133" name="Group 1132"/>
                    <p:cNvGrpSpPr/>
                    <p:nvPr/>
                  </p:nvGrpSpPr>
                  <p:grpSpPr>
                    <a:xfrm>
                      <a:off x="4751388" y="5797551"/>
                      <a:ext cx="301625" cy="1216025"/>
                      <a:chOff x="4751388" y="5797550"/>
                      <a:chExt cx="301625" cy="1216025"/>
                    </a:xfrm>
                    <a:solidFill>
                      <a:srgbClr val="FFFF66"/>
                    </a:solidFill>
                  </p:grpSpPr>
                  <p:sp>
                    <p:nvSpPr>
                      <p:cNvPr id="318" name="Rectangle 340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4751388" y="6153150"/>
                        <a:ext cx="301625" cy="860425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319" name="Freeform 341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4751388" y="6153150"/>
                        <a:ext cx="301625" cy="860425"/>
                      </a:xfrm>
                      <a:custGeom>
                        <a:avLst/>
                        <a:gdLst>
                          <a:gd name="T0" fmla="*/ 0 w 570"/>
                          <a:gd name="T1" fmla="*/ 0 h 1626"/>
                          <a:gd name="T2" fmla="*/ 570 w 570"/>
                          <a:gd name="T3" fmla="*/ 0 h 1626"/>
                          <a:gd name="T4" fmla="*/ 570 w 570"/>
                          <a:gd name="T5" fmla="*/ 1626 h 1626"/>
                          <a:gd name="T6" fmla="*/ 0 w 570"/>
                          <a:gd name="T7" fmla="*/ 1626 h 1626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0" h="1626">
                            <a:moveTo>
                              <a:pt x="0" y="0"/>
                            </a:moveTo>
                            <a:lnTo>
                              <a:pt x="570" y="0"/>
                            </a:lnTo>
                            <a:lnTo>
                              <a:pt x="570" y="1626"/>
                            </a:lnTo>
                            <a:lnTo>
                              <a:pt x="0" y="1626"/>
                            </a:lnTo>
                          </a:path>
                        </a:pathLst>
                      </a:custGeom>
                      <a:solidFill>
                        <a:schemeClr val="tx1">
                          <a:lumMod val="50000"/>
                          <a:lumOff val="50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88" name="Line 342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4751388" y="6153150"/>
                        <a:ext cx="0" cy="860425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6" name="Freeform 350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4902200" y="5797550"/>
                        <a:ext cx="0" cy="355600"/>
                      </a:xfrm>
                      <a:custGeom>
                        <a:avLst/>
                        <a:gdLst>
                          <a:gd name="T0" fmla="*/ 559 h 559"/>
                          <a:gd name="T1" fmla="*/ 0 h 559"/>
                          <a:gd name="T2" fmla="*/ 0 h 559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559">
                            <a:moveTo>
                              <a:pt x="0" y="559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7" name="Line 351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4875213" y="5797550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grpSp>
                  <p:nvGrpSpPr>
                    <p:cNvPr id="1134" name="Group 1133"/>
                    <p:cNvGrpSpPr/>
                    <p:nvPr/>
                  </p:nvGrpSpPr>
                  <p:grpSpPr>
                    <a:xfrm>
                      <a:off x="5153025" y="5921376"/>
                      <a:ext cx="301625" cy="1092200"/>
                      <a:chOff x="5153025" y="5921375"/>
                      <a:chExt cx="301625" cy="1092200"/>
                    </a:xfrm>
                    <a:solidFill>
                      <a:srgbClr val="FFFF00"/>
                    </a:solidFill>
                  </p:grpSpPr>
                  <p:sp>
                    <p:nvSpPr>
                      <p:cNvPr id="1089" name="Rectangle 343"/>
                      <p:cNvSpPr>
                        <a:spLocks noChangeArrowheads="1"/>
                      </p:cNvSpPr>
                      <p:nvPr/>
                    </p:nvSpPr>
                    <p:spPr bwMode="auto">
                      <a:xfrm>
                        <a:off x="5153025" y="5991225"/>
                        <a:ext cx="301625" cy="1022350"/>
                      </a:xfrm>
                      <a:prstGeom prst="rect">
                        <a:avLst/>
                      </a:prstGeom>
                      <a:grpFill/>
                      <a:ln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:ln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0" name="Freeform 344"/>
                      <p:cNvSpPr>
                        <a:spLocks/>
                      </p:cNvSpPr>
                      <p:nvPr/>
                    </p:nvSpPr>
                    <p:spPr bwMode="auto">
                      <a:xfrm>
                        <a:off x="5153025" y="5991225"/>
                        <a:ext cx="301625" cy="1022350"/>
                      </a:xfrm>
                      <a:custGeom>
                        <a:avLst/>
                        <a:gdLst>
                          <a:gd name="T0" fmla="*/ 0 w 571"/>
                          <a:gd name="T1" fmla="*/ 0 h 1933"/>
                          <a:gd name="T2" fmla="*/ 571 w 571"/>
                          <a:gd name="T3" fmla="*/ 0 h 1933"/>
                          <a:gd name="T4" fmla="*/ 571 w 571"/>
                          <a:gd name="T5" fmla="*/ 1933 h 1933"/>
                          <a:gd name="T6" fmla="*/ 0 w 571"/>
                          <a:gd name="T7" fmla="*/ 1933 h 1933"/>
                        </a:gdLst>
                        <a:ahLst/>
                        <a:cxnLst>
                          <a:cxn ang="0">
                            <a:pos x="T0" y="T1"/>
                          </a:cxn>
                          <a:cxn ang="0">
                            <a:pos x="T2" y="T3"/>
                          </a:cxn>
                          <a:cxn ang="0">
                            <a:pos x="T4" y="T5"/>
                          </a:cxn>
                          <a:cxn ang="0">
                            <a:pos x="T6" y="T7"/>
                          </a:cxn>
                        </a:cxnLst>
                        <a:rect l="0" t="0" r="r" b="b"/>
                        <a:pathLst>
                          <a:path w="571" h="1933">
                            <a:moveTo>
                              <a:pt x="0" y="0"/>
                            </a:moveTo>
                            <a:lnTo>
                              <a:pt x="571" y="0"/>
                            </a:lnTo>
                            <a:lnTo>
                              <a:pt x="571" y="1933"/>
                            </a:lnTo>
                            <a:lnTo>
                              <a:pt x="0" y="1933"/>
                            </a:lnTo>
                          </a:path>
                        </a:pathLst>
                      </a:custGeom>
                      <a:solidFill>
                        <a:schemeClr val="tx1">
                          <a:lumMod val="65000"/>
                          <a:lumOff val="35000"/>
                        </a:schemeClr>
                      </a:solidFill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1" name="Line 345"/>
                      <p:cNvSpPr>
                        <a:spLocks noChangeShapeType="1"/>
                      </p:cNvSpPr>
                      <p:nvPr/>
                    </p:nvSpPr>
                    <p:spPr bwMode="auto">
                      <a:xfrm flipV="1">
                        <a:off x="5153025" y="5991225"/>
                        <a:ext cx="0" cy="102235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8" name="Freeform 352"/>
                      <p:cNvSpPr>
                        <a:spLocks/>
                      </p:cNvSpPr>
                      <p:nvPr/>
                    </p:nvSpPr>
                    <p:spPr bwMode="auto">
                      <a:xfrm flipV="1">
                        <a:off x="5303838" y="5921375"/>
                        <a:ext cx="0" cy="69850"/>
                      </a:xfrm>
                      <a:custGeom>
                        <a:avLst/>
                        <a:gdLst>
                          <a:gd name="T0" fmla="*/ 110 h 110"/>
                          <a:gd name="T1" fmla="*/ 0 h 110"/>
                          <a:gd name="T2" fmla="*/ 0 h 110"/>
                        </a:gdLst>
                        <a:ahLst/>
                        <a:cxnLst>
                          <a:cxn ang="0">
                            <a:pos x="0" y="T0"/>
                          </a:cxn>
                          <a:cxn ang="0">
                            <a:pos x="0" y="T1"/>
                          </a:cxn>
                          <a:cxn ang="0">
                            <a:pos x="0" y="T2"/>
                          </a:cxn>
                        </a:cxnLst>
                        <a:rect l="0" t="0" r="r" b="b"/>
                        <a:pathLst>
                          <a:path h="110">
                            <a:moveTo>
                              <a:pt x="0" y="110"/>
                            </a:moveTo>
                            <a:lnTo>
                              <a:pt x="0" y="0"/>
                            </a:lnTo>
                            <a:lnTo>
                              <a:pt x="0" y="0"/>
                            </a:lnTo>
                          </a:path>
                        </a:pathLst>
                      </a:cu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  <p:sp>
                    <p:nvSpPr>
                      <p:cNvPr id="1099" name="Line 353"/>
                      <p:cNvSpPr>
                        <a:spLocks noChangeShapeType="1"/>
                      </p:cNvSpPr>
                      <p:nvPr/>
                    </p:nvSpPr>
                    <p:spPr bwMode="auto">
                      <a:xfrm>
                        <a:off x="5276850" y="5921375"/>
                        <a:ext cx="53975" cy="0"/>
                      </a:xfrm>
                      <a:prstGeom prst="line">
                        <a:avLst/>
                      </a:prstGeom>
                      <a:grpFill/>
                      <a:ln w="4763">
                        <a:solidFill>
                          <a:schemeClr val="tx1"/>
                        </a:solidFill>
                        <a:prstDash val="solid"/>
                        <a:round/>
                        <a:headEnd/>
                        <a:tailEnd/>
                      </a:ln>
                      <a:extLst/>
                    </p:spPr>
                    <p:txBody>
                      <a:bodyPr vert="horz" wrap="square" lIns="91440" tIns="45720" rIns="91440" bIns="45720" numCol="1" anchor="t" anchorCtr="0" compatLnSpc="1">
                        <a:prstTxWarp prst="textNoShape">
                          <a:avLst/>
                        </a:prstTxWarp>
                      </a:bodyPr>
                      <a:lstStyle/>
                      <a:p>
                        <a:endParaRPr lang="en-US"/>
                      </a:p>
                    </p:txBody>
                  </p:sp>
                </p:grpSp>
                <p:sp>
                  <p:nvSpPr>
                    <p:cNvPr id="1101" name="Line 355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298950" y="6964363"/>
                      <a:ext cx="0" cy="49213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02" name="Line 356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4700588" y="6964363"/>
                      <a:ext cx="0" cy="49213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03" name="Line 357"/>
                    <p:cNvSpPr>
                      <a:spLocks noChangeShapeType="1"/>
                    </p:cNvSpPr>
                    <p:nvPr/>
                  </p:nvSpPr>
                  <p:spPr bwMode="auto">
                    <a:xfrm flipV="1">
                      <a:off x="5102225" y="6964363"/>
                      <a:ext cx="0" cy="49213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07" name="Line 361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97313" y="6704013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08" name="Line 362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97313" y="639445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09" name="Line 363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97313" y="6083300"/>
                      <a:ext cx="50800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11" name="Line 365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97313" y="6859588"/>
                      <a:ext cx="33337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12" name="Line 366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97313" y="6548438"/>
                      <a:ext cx="33337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13" name="Line 367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97313" y="6238875"/>
                      <a:ext cx="33337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1114" name="Line 368"/>
                    <p:cNvSpPr>
                      <a:spLocks noChangeShapeType="1"/>
                    </p:cNvSpPr>
                    <p:nvPr/>
                  </p:nvSpPr>
                  <p:spPr bwMode="auto">
                    <a:xfrm>
                      <a:off x="3897313" y="5929313"/>
                      <a:ext cx="33337" cy="0"/>
                    </a:xfrm>
                    <a:prstGeom prst="line">
                      <a:avLst/>
                    </a:prstGeom>
                    <a:noFill/>
                    <a:ln w="4763">
                      <a:solidFill>
                        <a:schemeClr val="tx1"/>
                      </a:solidFill>
                      <a:prstDash val="solid"/>
                      <a:round/>
                      <a:headEnd/>
                      <a:tailEnd/>
                    </a:ln>
                    <a:extLst>
                      <a:ext uri="{909E8E84-426E-40DD-AFC4-6F175D3DCCD1}">
                        <a14:hiddenFill xmlns:a14="http://schemas.microsoft.com/office/drawing/2010/main">
                          <a:noFill/>
                        </a14:hiddenFill>
                      </a:ext>
                    </a:extLst>
                  </p:spPr>
                  <p:txBody>
                    <a:bodyPr vert="horz" wrap="square" lIns="91440" tIns="45720" rIns="91440" bIns="45720" numCol="1" anchor="t" anchorCtr="0" compatLnSpc="1">
                      <a:prstTxWarp prst="textNoShape">
                        <a:avLst/>
                      </a:prstTxWarp>
                    </a:bodyPr>
                    <a:lstStyle/>
                    <a:p>
                      <a:endParaRPr lang="en-US"/>
                    </a:p>
                  </p:txBody>
                </p:sp>
                <p:sp>
                  <p:nvSpPr>
                    <p:cNvPr id="427" name="Rectangle 426"/>
                    <p:cNvSpPr/>
                    <p:nvPr/>
                  </p:nvSpPr>
                  <p:spPr>
                    <a:xfrm>
                      <a:off x="3895407" y="5772151"/>
                      <a:ext cx="1608137" cy="1241425"/>
                    </a:xfrm>
                    <a:prstGeom prst="rect">
                      <a:avLst/>
                    </a:prstGeom>
                    <a:noFill/>
                    <a:ln w="9525"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</p:grpSp>
              <p:grpSp>
                <p:nvGrpSpPr>
                  <p:cNvPr id="516" name="Group 515"/>
                  <p:cNvGrpSpPr/>
                  <p:nvPr/>
                </p:nvGrpSpPr>
                <p:grpSpPr>
                  <a:xfrm>
                    <a:off x="3913981" y="7041729"/>
                    <a:ext cx="1577129" cy="367844"/>
                    <a:chOff x="1619464" y="1599671"/>
                    <a:chExt cx="1577129" cy="367844"/>
                  </a:xfrm>
                </p:grpSpPr>
                <p:sp>
                  <p:nvSpPr>
                    <p:cNvPr id="517" name="TextBox 516"/>
                    <p:cNvSpPr txBox="1"/>
                    <p:nvPr/>
                  </p:nvSpPr>
                  <p:spPr>
                    <a:xfrm>
                      <a:off x="1619464" y="1599671"/>
                      <a:ext cx="415498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ne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8" name="TextBox 517"/>
                    <p:cNvSpPr txBox="1"/>
                    <p:nvPr/>
                  </p:nvSpPr>
                  <p:spPr>
                    <a:xfrm>
                      <a:off x="2064382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19" name="TextBox 518"/>
                    <p:cNvSpPr txBox="1"/>
                    <p:nvPr/>
                  </p:nvSpPr>
                  <p:spPr>
                    <a:xfrm>
                      <a:off x="2466321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5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0" name="TextBox 519"/>
                    <p:cNvSpPr txBox="1"/>
                    <p:nvPr/>
                  </p:nvSpPr>
                  <p:spPr>
                    <a:xfrm>
                      <a:off x="2867657" y="1599671"/>
                      <a:ext cx="328936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0</a:t>
                      </a:r>
                      <a:endPara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  <p:sp>
                  <p:nvSpPr>
                    <p:cNvPr id="521" name="TextBox 520"/>
                    <p:cNvSpPr txBox="1"/>
                    <p:nvPr/>
                  </p:nvSpPr>
                  <p:spPr>
                    <a:xfrm>
                      <a:off x="2067238" y="1752071"/>
                      <a:ext cx="723275" cy="215444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r>
                        <a:rPr lang="en-US" sz="800" b="1" dirty="0" smtClean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AB30, µM</a:t>
                      </a:r>
                      <a:endParaRPr lang="en-US" sz="800" b="1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p:txBody>
                </p:sp>
              </p:grpSp>
              <p:sp>
                <p:nvSpPr>
                  <p:cNvPr id="559" name="TextBox 558"/>
                  <p:cNvSpPr txBox="1"/>
                  <p:nvPr/>
                </p:nvSpPr>
                <p:spPr>
                  <a:xfrm>
                    <a:off x="3633464" y="5972982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.2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60" name="TextBox 559"/>
                  <p:cNvSpPr txBox="1"/>
                  <p:nvPr/>
                </p:nvSpPr>
                <p:spPr>
                  <a:xfrm>
                    <a:off x="3633464" y="6289110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8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61" name="TextBox 560"/>
                  <p:cNvSpPr txBox="1"/>
                  <p:nvPr/>
                </p:nvSpPr>
                <p:spPr>
                  <a:xfrm>
                    <a:off x="3633464" y="6591116"/>
                    <a:ext cx="328936" cy="215444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.4</a:t>
                    </a:r>
                    <a:endParaRPr lang="en-US" sz="8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571" name="TextBox 570"/>
                <p:cNvSpPr txBox="1"/>
                <p:nvPr/>
              </p:nvSpPr>
              <p:spPr>
                <a:xfrm rot="16200000">
                  <a:off x="3179950" y="6267996"/>
                  <a:ext cx="865943" cy="215444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SREBP2</a:t>
                  </a:r>
                  <a:r>
                    <a:rPr lang="en-US" sz="800" b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/</a:t>
                  </a:r>
                  <a:r>
                    <a:rPr lang="en-US" sz="800" b="1" i="1" dirty="0" smtClean="0">
                      <a:latin typeface="Arial" panose="020B0604020202020204" pitchFamily="34" charset="0"/>
                      <a:cs typeface="Arial" panose="020B0604020202020204" pitchFamily="34" charset="0"/>
                    </a:rPr>
                    <a:t>PPIA</a:t>
                  </a:r>
                  <a:endParaRPr lang="en-US" sz="800" b="1" i="1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</p:grpSp>
        <p:sp>
          <p:nvSpPr>
            <p:cNvPr id="2" name="TextBox 1"/>
            <p:cNvSpPr txBox="1"/>
            <p:nvPr/>
          </p:nvSpPr>
          <p:spPr>
            <a:xfrm>
              <a:off x="2883666" y="2819400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0" name="TextBox 399"/>
            <p:cNvSpPr txBox="1"/>
            <p:nvPr/>
          </p:nvSpPr>
          <p:spPr>
            <a:xfrm>
              <a:off x="2123065" y="1459468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5" name="TextBox 404"/>
            <p:cNvSpPr txBox="1"/>
            <p:nvPr/>
          </p:nvSpPr>
          <p:spPr>
            <a:xfrm>
              <a:off x="2523206" y="1173390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6" name="TextBox 405"/>
            <p:cNvSpPr txBox="1"/>
            <p:nvPr/>
          </p:nvSpPr>
          <p:spPr>
            <a:xfrm>
              <a:off x="2885164" y="1066482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7" name="TextBox 406"/>
            <p:cNvSpPr txBox="1"/>
            <p:nvPr/>
          </p:nvSpPr>
          <p:spPr>
            <a:xfrm>
              <a:off x="5257800" y="3505795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8" name="TextBox 407"/>
            <p:cNvSpPr txBox="1"/>
            <p:nvPr/>
          </p:nvSpPr>
          <p:spPr>
            <a:xfrm>
              <a:off x="2926340" y="6328137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9" name="TextBox 408"/>
            <p:cNvSpPr txBox="1"/>
            <p:nvPr/>
          </p:nvSpPr>
          <p:spPr>
            <a:xfrm>
              <a:off x="5299971" y="1081960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0" name="TextBox 409"/>
            <p:cNvSpPr txBox="1"/>
            <p:nvPr/>
          </p:nvSpPr>
          <p:spPr>
            <a:xfrm>
              <a:off x="2928550" y="4886082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1" name="TextBox 410"/>
            <p:cNvSpPr txBox="1"/>
            <p:nvPr/>
          </p:nvSpPr>
          <p:spPr>
            <a:xfrm>
              <a:off x="2123065" y="4812268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2" name="TextBox 411"/>
            <p:cNvSpPr txBox="1"/>
            <p:nvPr/>
          </p:nvSpPr>
          <p:spPr>
            <a:xfrm>
              <a:off x="5302684" y="4876800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3" name="TextBox 412"/>
            <p:cNvSpPr txBox="1"/>
            <p:nvPr/>
          </p:nvSpPr>
          <p:spPr>
            <a:xfrm>
              <a:off x="5258299" y="6302799"/>
              <a:ext cx="36420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*</a:t>
              </a:r>
              <a:endParaRPr lang="en-US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22160482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</TotalTime>
  <Words>105</Words>
  <Application>Microsoft Office PowerPoint</Application>
  <PresentationFormat>On-screen Show (4:3)</PresentationFormat>
  <Paragraphs>8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User</cp:lastModifiedBy>
  <cp:revision>11</cp:revision>
  <dcterms:created xsi:type="dcterms:W3CDTF">2015-08-05T22:29:47Z</dcterms:created>
  <dcterms:modified xsi:type="dcterms:W3CDTF">2016-02-02T16:55:48Z</dcterms:modified>
</cp:coreProperties>
</file>